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1572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56932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5443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856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4359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2128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9568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950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06407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6397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2589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77727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7A329A-89F6-4AC6-B177-5992A3398ACC}" type="datetimeFigureOut">
              <a:rPr kumimoji="1" lang="ja-JP" altLang="en-US" smtClean="0"/>
              <a:t>2021/12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6B2464-D6FA-43B0-BDBF-06A10842CC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39666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256025C9-30C8-4D14-A080-0F8A2833F79C}"/>
              </a:ext>
            </a:extLst>
          </p:cNvPr>
          <p:cNvSpPr/>
          <p:nvPr/>
        </p:nvSpPr>
        <p:spPr>
          <a:xfrm rot="16200000">
            <a:off x="-299908" y="2197624"/>
            <a:ext cx="10374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rvival rate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B21E86C4-A956-4BA5-8596-F59C2ECA403E}"/>
              </a:ext>
            </a:extLst>
          </p:cNvPr>
          <p:cNvSpPr/>
          <p:nvPr/>
        </p:nvSpPr>
        <p:spPr>
          <a:xfrm>
            <a:off x="1715405" y="4113599"/>
            <a:ext cx="15937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nths after surger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A79C9C97-966D-4759-B5B4-177891524C80}"/>
              </a:ext>
            </a:extLst>
          </p:cNvPr>
          <p:cNvSpPr/>
          <p:nvPr/>
        </p:nvSpPr>
        <p:spPr>
          <a:xfrm rot="16200000">
            <a:off x="4244834" y="2235696"/>
            <a:ext cx="103746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rvival rate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7B1BA6E3-1350-4C76-A8E6-D7E401B41938}"/>
              </a:ext>
            </a:extLst>
          </p:cNvPr>
          <p:cNvSpPr/>
          <p:nvPr/>
        </p:nvSpPr>
        <p:spPr>
          <a:xfrm>
            <a:off x="6260147" y="4119397"/>
            <a:ext cx="159370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onths after surgery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C28EA05-5657-4CAA-802A-1D6621965879}"/>
              </a:ext>
            </a:extLst>
          </p:cNvPr>
          <p:cNvSpPr/>
          <p:nvPr/>
        </p:nvSpPr>
        <p:spPr>
          <a:xfrm>
            <a:off x="804976" y="3466744"/>
            <a:ext cx="8274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0020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95">
            <a:extLst>
              <a:ext uri="{FF2B5EF4-FFF2-40B4-BE49-F238E27FC236}">
                <a16:creationId xmlns:a16="http://schemas.microsoft.com/office/drawing/2014/main" id="{BADD298A-DEB8-4EB7-9DAF-83FD9B78EDD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21342" y="1521324"/>
            <a:ext cx="112851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900" dirty="0">
                <a:cs typeface="Arial" panose="020B0604020202020204" pitchFamily="34" charset="0"/>
              </a:rPr>
              <a:t>PT High complication-</a:t>
            </a:r>
            <a:endParaRPr kumimoji="1" lang="ja-JP" altLang="ja-JP" sz="9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grpSp>
        <p:nvGrpSpPr>
          <p:cNvPr id="10" name="Group 4">
            <a:extLst>
              <a:ext uri="{FF2B5EF4-FFF2-40B4-BE49-F238E27FC236}">
                <a16:creationId xmlns:a16="http://schemas.microsoft.com/office/drawing/2014/main" id="{AAD056D4-C4BB-462B-BC4E-034D686A4FFD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-166956" y="1345004"/>
            <a:ext cx="4438183" cy="2812483"/>
            <a:chOff x="-2122" y="1594"/>
            <a:chExt cx="2083" cy="1320"/>
          </a:xfrm>
        </p:grpSpPr>
        <p:sp>
          <p:nvSpPr>
            <p:cNvPr id="11" name="Rectangle 5">
              <a:extLst>
                <a:ext uri="{FF2B5EF4-FFF2-40B4-BE49-F238E27FC236}">
                  <a16:creationId xmlns:a16="http://schemas.microsoft.com/office/drawing/2014/main" id="{84134D76-C421-45E5-888D-C548BC01D3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122" y="1599"/>
              <a:ext cx="5" cy="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6">
              <a:extLst>
                <a:ext uri="{FF2B5EF4-FFF2-40B4-BE49-F238E27FC236}">
                  <a16:creationId xmlns:a16="http://schemas.microsoft.com/office/drawing/2014/main" id="{10771B84-D1F8-44D9-AB66-3B8E746286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122" y="1599"/>
              <a:ext cx="5" cy="5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Line 7">
              <a:extLst>
                <a:ext uri="{FF2B5EF4-FFF2-40B4-BE49-F238E27FC236}">
                  <a16:creationId xmlns:a16="http://schemas.microsoft.com/office/drawing/2014/main" id="{8969068A-50C9-42F5-A028-59C264365D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66" y="2678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Line 8">
              <a:extLst>
                <a:ext uri="{FF2B5EF4-FFF2-40B4-BE49-F238E27FC236}">
                  <a16:creationId xmlns:a16="http://schemas.microsoft.com/office/drawing/2014/main" id="{7EC642BA-6AC1-42D0-8D03-32C44199FE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66" y="2447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Line 9">
              <a:extLst>
                <a:ext uri="{FF2B5EF4-FFF2-40B4-BE49-F238E27FC236}">
                  <a16:creationId xmlns:a16="http://schemas.microsoft.com/office/drawing/2014/main" id="{53AA3F22-204D-47DD-96FD-3BA71F6C8E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66" y="2216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Line 10">
              <a:extLst>
                <a:ext uri="{FF2B5EF4-FFF2-40B4-BE49-F238E27FC236}">
                  <a16:creationId xmlns:a16="http://schemas.microsoft.com/office/drawing/2014/main" id="{AE933517-A05E-4F60-B058-5AA939F541B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66" y="1984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Line 11">
              <a:extLst>
                <a:ext uri="{FF2B5EF4-FFF2-40B4-BE49-F238E27FC236}">
                  <a16:creationId xmlns:a16="http://schemas.microsoft.com/office/drawing/2014/main" id="{EBE33AE1-29B8-4A5E-9698-6AC7EE9066B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66" y="1753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Line 12">
              <a:extLst>
                <a:ext uri="{FF2B5EF4-FFF2-40B4-BE49-F238E27FC236}">
                  <a16:creationId xmlns:a16="http://schemas.microsoft.com/office/drawing/2014/main" id="{DE08AD0B-4D45-4CD3-94CB-BA9BACC40A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80" y="2794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Line 13">
              <a:extLst>
                <a:ext uri="{FF2B5EF4-FFF2-40B4-BE49-F238E27FC236}">
                  <a16:creationId xmlns:a16="http://schemas.microsoft.com/office/drawing/2014/main" id="{F0A5923E-9954-4080-8F52-569ACD703E5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80" y="2562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Line 14">
              <a:extLst>
                <a:ext uri="{FF2B5EF4-FFF2-40B4-BE49-F238E27FC236}">
                  <a16:creationId xmlns:a16="http://schemas.microsoft.com/office/drawing/2014/main" id="{771910B2-DC5C-418C-9024-AAF071455A5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80" y="2331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Line 15">
              <a:extLst>
                <a:ext uri="{FF2B5EF4-FFF2-40B4-BE49-F238E27FC236}">
                  <a16:creationId xmlns:a16="http://schemas.microsoft.com/office/drawing/2014/main" id="{50ECABDC-EF96-4103-9700-DD34AEE75CF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80" y="2100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Line 16">
              <a:extLst>
                <a:ext uri="{FF2B5EF4-FFF2-40B4-BE49-F238E27FC236}">
                  <a16:creationId xmlns:a16="http://schemas.microsoft.com/office/drawing/2014/main" id="{B8B14A47-CE32-4C01-9AF5-C99C9040E6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80" y="1869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Line 17">
              <a:extLst>
                <a:ext uri="{FF2B5EF4-FFF2-40B4-BE49-F238E27FC236}">
                  <a16:creationId xmlns:a16="http://schemas.microsoft.com/office/drawing/2014/main" id="{E9EAA57A-4C5C-4441-A13D-F23DBD35141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80" y="1638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Rectangle 18">
              <a:extLst>
                <a:ext uri="{FF2B5EF4-FFF2-40B4-BE49-F238E27FC236}">
                  <a16:creationId xmlns:a16="http://schemas.microsoft.com/office/drawing/2014/main" id="{CE51AAE0-427F-4B54-9053-6354E57AC9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28" y="2750"/>
              <a:ext cx="4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Rectangle 19">
              <a:extLst>
                <a:ext uri="{FF2B5EF4-FFF2-40B4-BE49-F238E27FC236}">
                  <a16:creationId xmlns:a16="http://schemas.microsoft.com/office/drawing/2014/main" id="{02A5D282-2080-4F99-983A-AF70FAC269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81" y="2519"/>
              <a:ext cx="10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Rectangle 20">
              <a:extLst>
                <a:ext uri="{FF2B5EF4-FFF2-40B4-BE49-F238E27FC236}">
                  <a16:creationId xmlns:a16="http://schemas.microsoft.com/office/drawing/2014/main" id="{FDEABC0E-F42E-4F3D-A89C-E1D5721BC5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81" y="2287"/>
              <a:ext cx="10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" name="Rectangle 21">
              <a:extLst>
                <a:ext uri="{FF2B5EF4-FFF2-40B4-BE49-F238E27FC236}">
                  <a16:creationId xmlns:a16="http://schemas.microsoft.com/office/drawing/2014/main" id="{EE041C05-3EF6-431C-9D49-485A86EC60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81" y="2056"/>
              <a:ext cx="10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8" name="Rectangle 22">
              <a:extLst>
                <a:ext uri="{FF2B5EF4-FFF2-40B4-BE49-F238E27FC236}">
                  <a16:creationId xmlns:a16="http://schemas.microsoft.com/office/drawing/2014/main" id="{919ACB31-CB23-49AE-9D0D-098F4FEC36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81" y="1825"/>
              <a:ext cx="10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9" name="Rectangle 23">
              <a:extLst>
                <a:ext uri="{FF2B5EF4-FFF2-40B4-BE49-F238E27FC236}">
                  <a16:creationId xmlns:a16="http://schemas.microsoft.com/office/drawing/2014/main" id="{8E189290-14A3-4A4B-8497-BC019D0F77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881" y="1594"/>
              <a:ext cx="10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" name="Freeform 26">
              <a:extLst>
                <a:ext uri="{FF2B5EF4-FFF2-40B4-BE49-F238E27FC236}">
                  <a16:creationId xmlns:a16="http://schemas.microsoft.com/office/drawing/2014/main" id="{4C77533A-F4B1-4D1C-9514-CE4A039D2E34}"/>
                </a:ext>
              </a:extLst>
            </p:cNvPr>
            <p:cNvSpPr>
              <a:spLocks/>
            </p:cNvSpPr>
            <p:nvPr/>
          </p:nvSpPr>
          <p:spPr bwMode="auto">
            <a:xfrm>
              <a:off x="-1752" y="1638"/>
              <a:ext cx="1713" cy="173"/>
            </a:xfrm>
            <a:custGeom>
              <a:avLst/>
              <a:gdLst>
                <a:gd name="T0" fmla="*/ 0 w 1713"/>
                <a:gd name="T1" fmla="*/ 0 h 173"/>
                <a:gd name="T2" fmla="*/ 284 w 1713"/>
                <a:gd name="T3" fmla="*/ 0 h 173"/>
                <a:gd name="T4" fmla="*/ 357 w 1713"/>
                <a:gd name="T5" fmla="*/ 0 h 173"/>
                <a:gd name="T6" fmla="*/ 357 w 1713"/>
                <a:gd name="T7" fmla="*/ 14 h 173"/>
                <a:gd name="T8" fmla="*/ 357 w 1713"/>
                <a:gd name="T9" fmla="*/ 14 h 173"/>
                <a:gd name="T10" fmla="*/ 357 w 1713"/>
                <a:gd name="T11" fmla="*/ 28 h 173"/>
                <a:gd name="T12" fmla="*/ 448 w 1713"/>
                <a:gd name="T13" fmla="*/ 28 h 173"/>
                <a:gd name="T14" fmla="*/ 448 w 1713"/>
                <a:gd name="T15" fmla="*/ 43 h 173"/>
                <a:gd name="T16" fmla="*/ 669 w 1713"/>
                <a:gd name="T17" fmla="*/ 43 h 173"/>
                <a:gd name="T18" fmla="*/ 669 w 1713"/>
                <a:gd name="T19" fmla="*/ 62 h 173"/>
                <a:gd name="T20" fmla="*/ 717 w 1713"/>
                <a:gd name="T21" fmla="*/ 62 h 173"/>
                <a:gd name="T22" fmla="*/ 775 w 1713"/>
                <a:gd name="T23" fmla="*/ 62 h 173"/>
                <a:gd name="T24" fmla="*/ 775 w 1713"/>
                <a:gd name="T25" fmla="*/ 77 h 173"/>
                <a:gd name="T26" fmla="*/ 775 w 1713"/>
                <a:gd name="T27" fmla="*/ 91 h 173"/>
                <a:gd name="T28" fmla="*/ 780 w 1713"/>
                <a:gd name="T29" fmla="*/ 91 h 173"/>
                <a:gd name="T30" fmla="*/ 843 w 1713"/>
                <a:gd name="T31" fmla="*/ 91 h 173"/>
                <a:gd name="T32" fmla="*/ 843 w 1713"/>
                <a:gd name="T33" fmla="*/ 106 h 173"/>
                <a:gd name="T34" fmla="*/ 881 w 1713"/>
                <a:gd name="T35" fmla="*/ 106 h 173"/>
                <a:gd name="T36" fmla="*/ 881 w 1713"/>
                <a:gd name="T37" fmla="*/ 125 h 173"/>
                <a:gd name="T38" fmla="*/ 895 w 1713"/>
                <a:gd name="T39" fmla="*/ 125 h 173"/>
                <a:gd name="T40" fmla="*/ 968 w 1713"/>
                <a:gd name="T41" fmla="*/ 125 h 173"/>
                <a:gd name="T42" fmla="*/ 1227 w 1713"/>
                <a:gd name="T43" fmla="*/ 125 h 173"/>
                <a:gd name="T44" fmla="*/ 1227 w 1713"/>
                <a:gd name="T45" fmla="*/ 139 h 173"/>
                <a:gd name="T46" fmla="*/ 1391 w 1713"/>
                <a:gd name="T47" fmla="*/ 139 h 173"/>
                <a:gd name="T48" fmla="*/ 1391 w 1713"/>
                <a:gd name="T49" fmla="*/ 158 h 173"/>
                <a:gd name="T50" fmla="*/ 1454 w 1713"/>
                <a:gd name="T51" fmla="*/ 158 h 173"/>
                <a:gd name="T52" fmla="*/ 1454 w 1713"/>
                <a:gd name="T53" fmla="*/ 173 h 173"/>
                <a:gd name="T54" fmla="*/ 1641 w 1713"/>
                <a:gd name="T55" fmla="*/ 173 h 173"/>
                <a:gd name="T56" fmla="*/ 1646 w 1713"/>
                <a:gd name="T57" fmla="*/ 173 h 173"/>
                <a:gd name="T58" fmla="*/ 1689 w 1713"/>
                <a:gd name="T59" fmla="*/ 173 h 173"/>
                <a:gd name="T60" fmla="*/ 1699 w 1713"/>
                <a:gd name="T61" fmla="*/ 173 h 173"/>
                <a:gd name="T62" fmla="*/ 1709 w 1713"/>
                <a:gd name="T63" fmla="*/ 173 h 173"/>
                <a:gd name="T64" fmla="*/ 1713 w 1713"/>
                <a:gd name="T65" fmla="*/ 173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713" h="173">
                  <a:moveTo>
                    <a:pt x="0" y="0"/>
                  </a:moveTo>
                  <a:lnTo>
                    <a:pt x="284" y="0"/>
                  </a:lnTo>
                  <a:lnTo>
                    <a:pt x="357" y="0"/>
                  </a:lnTo>
                  <a:lnTo>
                    <a:pt x="357" y="14"/>
                  </a:lnTo>
                  <a:lnTo>
                    <a:pt x="357" y="14"/>
                  </a:lnTo>
                  <a:lnTo>
                    <a:pt x="357" y="28"/>
                  </a:lnTo>
                  <a:lnTo>
                    <a:pt x="448" y="28"/>
                  </a:lnTo>
                  <a:lnTo>
                    <a:pt x="448" y="43"/>
                  </a:lnTo>
                  <a:lnTo>
                    <a:pt x="669" y="43"/>
                  </a:lnTo>
                  <a:lnTo>
                    <a:pt x="669" y="62"/>
                  </a:lnTo>
                  <a:lnTo>
                    <a:pt x="717" y="62"/>
                  </a:lnTo>
                  <a:lnTo>
                    <a:pt x="775" y="62"/>
                  </a:lnTo>
                  <a:lnTo>
                    <a:pt x="775" y="77"/>
                  </a:lnTo>
                  <a:lnTo>
                    <a:pt x="775" y="91"/>
                  </a:lnTo>
                  <a:lnTo>
                    <a:pt x="780" y="91"/>
                  </a:lnTo>
                  <a:lnTo>
                    <a:pt x="843" y="91"/>
                  </a:lnTo>
                  <a:lnTo>
                    <a:pt x="843" y="106"/>
                  </a:lnTo>
                  <a:lnTo>
                    <a:pt x="881" y="106"/>
                  </a:lnTo>
                  <a:lnTo>
                    <a:pt x="881" y="125"/>
                  </a:lnTo>
                  <a:lnTo>
                    <a:pt x="895" y="125"/>
                  </a:lnTo>
                  <a:lnTo>
                    <a:pt x="968" y="125"/>
                  </a:lnTo>
                  <a:lnTo>
                    <a:pt x="1227" y="125"/>
                  </a:lnTo>
                  <a:lnTo>
                    <a:pt x="1227" y="139"/>
                  </a:lnTo>
                  <a:lnTo>
                    <a:pt x="1391" y="139"/>
                  </a:lnTo>
                  <a:lnTo>
                    <a:pt x="1391" y="158"/>
                  </a:lnTo>
                  <a:lnTo>
                    <a:pt x="1454" y="158"/>
                  </a:lnTo>
                  <a:lnTo>
                    <a:pt x="1454" y="173"/>
                  </a:lnTo>
                  <a:lnTo>
                    <a:pt x="1641" y="173"/>
                  </a:lnTo>
                  <a:lnTo>
                    <a:pt x="1646" y="173"/>
                  </a:lnTo>
                  <a:lnTo>
                    <a:pt x="1689" y="173"/>
                  </a:lnTo>
                  <a:lnTo>
                    <a:pt x="1699" y="173"/>
                  </a:lnTo>
                  <a:lnTo>
                    <a:pt x="1709" y="173"/>
                  </a:lnTo>
                  <a:lnTo>
                    <a:pt x="1713" y="173"/>
                  </a:lnTo>
                </a:path>
              </a:pathLst>
            </a:custGeom>
            <a:solidFill>
              <a:srgbClr val="FFFFFF"/>
            </a:solidFill>
            <a:ln w="12700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Freeform 27">
              <a:extLst>
                <a:ext uri="{FF2B5EF4-FFF2-40B4-BE49-F238E27FC236}">
                  <a16:creationId xmlns:a16="http://schemas.microsoft.com/office/drawing/2014/main" id="{40DC5998-6083-461C-B4E5-2FAA7DFED697}"/>
                </a:ext>
              </a:extLst>
            </p:cNvPr>
            <p:cNvSpPr>
              <a:spLocks/>
            </p:cNvSpPr>
            <p:nvPr/>
          </p:nvSpPr>
          <p:spPr bwMode="auto">
            <a:xfrm>
              <a:off x="-1752" y="1638"/>
              <a:ext cx="1713" cy="476"/>
            </a:xfrm>
            <a:custGeom>
              <a:avLst/>
              <a:gdLst>
                <a:gd name="T0" fmla="*/ 0 w 1713"/>
                <a:gd name="T1" fmla="*/ 0 h 476"/>
                <a:gd name="T2" fmla="*/ 0 w 1713"/>
                <a:gd name="T3" fmla="*/ 0 h 476"/>
                <a:gd name="T4" fmla="*/ 0 w 1713"/>
                <a:gd name="T5" fmla="*/ 24 h 476"/>
                <a:gd name="T6" fmla="*/ 130 w 1713"/>
                <a:gd name="T7" fmla="*/ 24 h 476"/>
                <a:gd name="T8" fmla="*/ 130 w 1713"/>
                <a:gd name="T9" fmla="*/ 48 h 476"/>
                <a:gd name="T10" fmla="*/ 150 w 1713"/>
                <a:gd name="T11" fmla="*/ 48 h 476"/>
                <a:gd name="T12" fmla="*/ 188 w 1713"/>
                <a:gd name="T13" fmla="*/ 48 h 476"/>
                <a:gd name="T14" fmla="*/ 188 w 1713"/>
                <a:gd name="T15" fmla="*/ 72 h 476"/>
                <a:gd name="T16" fmla="*/ 304 w 1713"/>
                <a:gd name="T17" fmla="*/ 72 h 476"/>
                <a:gd name="T18" fmla="*/ 304 w 1713"/>
                <a:gd name="T19" fmla="*/ 96 h 476"/>
                <a:gd name="T20" fmla="*/ 308 w 1713"/>
                <a:gd name="T21" fmla="*/ 120 h 476"/>
                <a:gd name="T22" fmla="*/ 434 w 1713"/>
                <a:gd name="T23" fmla="*/ 120 h 476"/>
                <a:gd name="T24" fmla="*/ 434 w 1713"/>
                <a:gd name="T25" fmla="*/ 149 h 476"/>
                <a:gd name="T26" fmla="*/ 458 w 1713"/>
                <a:gd name="T27" fmla="*/ 149 h 476"/>
                <a:gd name="T28" fmla="*/ 563 w 1713"/>
                <a:gd name="T29" fmla="*/ 149 h 476"/>
                <a:gd name="T30" fmla="*/ 563 w 1713"/>
                <a:gd name="T31" fmla="*/ 173 h 476"/>
                <a:gd name="T32" fmla="*/ 583 w 1713"/>
                <a:gd name="T33" fmla="*/ 173 h 476"/>
                <a:gd name="T34" fmla="*/ 592 w 1713"/>
                <a:gd name="T35" fmla="*/ 173 h 476"/>
                <a:gd name="T36" fmla="*/ 592 w 1713"/>
                <a:gd name="T37" fmla="*/ 202 h 476"/>
                <a:gd name="T38" fmla="*/ 592 w 1713"/>
                <a:gd name="T39" fmla="*/ 226 h 476"/>
                <a:gd name="T40" fmla="*/ 660 w 1713"/>
                <a:gd name="T41" fmla="*/ 226 h 476"/>
                <a:gd name="T42" fmla="*/ 660 w 1713"/>
                <a:gd name="T43" fmla="*/ 255 h 476"/>
                <a:gd name="T44" fmla="*/ 910 w 1713"/>
                <a:gd name="T45" fmla="*/ 255 h 476"/>
                <a:gd name="T46" fmla="*/ 919 w 1713"/>
                <a:gd name="T47" fmla="*/ 255 h 476"/>
                <a:gd name="T48" fmla="*/ 919 w 1713"/>
                <a:gd name="T49" fmla="*/ 279 h 476"/>
                <a:gd name="T50" fmla="*/ 934 w 1713"/>
                <a:gd name="T51" fmla="*/ 279 h 476"/>
                <a:gd name="T52" fmla="*/ 934 w 1713"/>
                <a:gd name="T53" fmla="*/ 308 h 476"/>
                <a:gd name="T54" fmla="*/ 1040 w 1713"/>
                <a:gd name="T55" fmla="*/ 308 h 476"/>
                <a:gd name="T56" fmla="*/ 1049 w 1713"/>
                <a:gd name="T57" fmla="*/ 308 h 476"/>
                <a:gd name="T58" fmla="*/ 1049 w 1713"/>
                <a:gd name="T59" fmla="*/ 337 h 476"/>
                <a:gd name="T60" fmla="*/ 1073 w 1713"/>
                <a:gd name="T61" fmla="*/ 337 h 476"/>
                <a:gd name="T62" fmla="*/ 1073 w 1713"/>
                <a:gd name="T63" fmla="*/ 366 h 476"/>
                <a:gd name="T64" fmla="*/ 1083 w 1713"/>
                <a:gd name="T65" fmla="*/ 366 h 476"/>
                <a:gd name="T66" fmla="*/ 1083 w 1713"/>
                <a:gd name="T67" fmla="*/ 390 h 476"/>
                <a:gd name="T68" fmla="*/ 1098 w 1713"/>
                <a:gd name="T69" fmla="*/ 390 h 476"/>
                <a:gd name="T70" fmla="*/ 1098 w 1713"/>
                <a:gd name="T71" fmla="*/ 419 h 476"/>
                <a:gd name="T72" fmla="*/ 1136 w 1713"/>
                <a:gd name="T73" fmla="*/ 419 h 476"/>
                <a:gd name="T74" fmla="*/ 1136 w 1713"/>
                <a:gd name="T75" fmla="*/ 448 h 476"/>
                <a:gd name="T76" fmla="*/ 1276 w 1713"/>
                <a:gd name="T77" fmla="*/ 448 h 476"/>
                <a:gd name="T78" fmla="*/ 1328 w 1713"/>
                <a:gd name="T79" fmla="*/ 448 h 476"/>
                <a:gd name="T80" fmla="*/ 1328 w 1713"/>
                <a:gd name="T81" fmla="*/ 476 h 476"/>
                <a:gd name="T82" fmla="*/ 1608 w 1713"/>
                <a:gd name="T83" fmla="*/ 476 h 476"/>
                <a:gd name="T84" fmla="*/ 1713 w 1713"/>
                <a:gd name="T85" fmla="*/ 476 h 4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713" h="476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  <a:lnTo>
                    <a:pt x="130" y="24"/>
                  </a:lnTo>
                  <a:lnTo>
                    <a:pt x="130" y="48"/>
                  </a:lnTo>
                  <a:lnTo>
                    <a:pt x="150" y="48"/>
                  </a:lnTo>
                  <a:lnTo>
                    <a:pt x="188" y="48"/>
                  </a:lnTo>
                  <a:lnTo>
                    <a:pt x="188" y="72"/>
                  </a:lnTo>
                  <a:lnTo>
                    <a:pt x="304" y="72"/>
                  </a:lnTo>
                  <a:lnTo>
                    <a:pt x="304" y="96"/>
                  </a:lnTo>
                  <a:lnTo>
                    <a:pt x="308" y="120"/>
                  </a:lnTo>
                  <a:lnTo>
                    <a:pt x="434" y="120"/>
                  </a:lnTo>
                  <a:lnTo>
                    <a:pt x="434" y="149"/>
                  </a:lnTo>
                  <a:lnTo>
                    <a:pt x="458" y="149"/>
                  </a:lnTo>
                  <a:lnTo>
                    <a:pt x="563" y="149"/>
                  </a:lnTo>
                  <a:lnTo>
                    <a:pt x="563" y="173"/>
                  </a:lnTo>
                  <a:lnTo>
                    <a:pt x="583" y="173"/>
                  </a:lnTo>
                  <a:lnTo>
                    <a:pt x="592" y="173"/>
                  </a:lnTo>
                  <a:lnTo>
                    <a:pt x="592" y="202"/>
                  </a:lnTo>
                  <a:lnTo>
                    <a:pt x="592" y="226"/>
                  </a:lnTo>
                  <a:lnTo>
                    <a:pt x="660" y="226"/>
                  </a:lnTo>
                  <a:lnTo>
                    <a:pt x="660" y="255"/>
                  </a:lnTo>
                  <a:lnTo>
                    <a:pt x="910" y="255"/>
                  </a:lnTo>
                  <a:lnTo>
                    <a:pt x="919" y="255"/>
                  </a:lnTo>
                  <a:lnTo>
                    <a:pt x="919" y="279"/>
                  </a:lnTo>
                  <a:lnTo>
                    <a:pt x="934" y="279"/>
                  </a:lnTo>
                  <a:lnTo>
                    <a:pt x="934" y="308"/>
                  </a:lnTo>
                  <a:lnTo>
                    <a:pt x="1040" y="308"/>
                  </a:lnTo>
                  <a:lnTo>
                    <a:pt x="1049" y="308"/>
                  </a:lnTo>
                  <a:lnTo>
                    <a:pt x="1049" y="337"/>
                  </a:lnTo>
                  <a:lnTo>
                    <a:pt x="1073" y="337"/>
                  </a:lnTo>
                  <a:lnTo>
                    <a:pt x="1073" y="366"/>
                  </a:lnTo>
                  <a:lnTo>
                    <a:pt x="1083" y="366"/>
                  </a:lnTo>
                  <a:lnTo>
                    <a:pt x="1083" y="390"/>
                  </a:lnTo>
                  <a:lnTo>
                    <a:pt x="1098" y="390"/>
                  </a:lnTo>
                  <a:lnTo>
                    <a:pt x="1098" y="419"/>
                  </a:lnTo>
                  <a:lnTo>
                    <a:pt x="1136" y="419"/>
                  </a:lnTo>
                  <a:lnTo>
                    <a:pt x="1136" y="448"/>
                  </a:lnTo>
                  <a:lnTo>
                    <a:pt x="1276" y="448"/>
                  </a:lnTo>
                  <a:lnTo>
                    <a:pt x="1328" y="448"/>
                  </a:lnTo>
                  <a:lnTo>
                    <a:pt x="1328" y="476"/>
                  </a:lnTo>
                  <a:lnTo>
                    <a:pt x="1608" y="476"/>
                  </a:lnTo>
                  <a:lnTo>
                    <a:pt x="1713" y="476"/>
                  </a:lnTo>
                </a:path>
              </a:pathLst>
            </a:custGeom>
            <a:noFill/>
            <a:ln w="12700">
              <a:solidFill>
                <a:schemeClr val="tx1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Freeform 28">
              <a:extLst>
                <a:ext uri="{FF2B5EF4-FFF2-40B4-BE49-F238E27FC236}">
                  <a16:creationId xmlns:a16="http://schemas.microsoft.com/office/drawing/2014/main" id="{239F0FE7-4922-4B52-A64F-1CB45032705F}"/>
                </a:ext>
              </a:extLst>
            </p:cNvPr>
            <p:cNvSpPr>
              <a:spLocks/>
            </p:cNvSpPr>
            <p:nvPr/>
          </p:nvSpPr>
          <p:spPr bwMode="auto">
            <a:xfrm>
              <a:off x="-1752" y="1638"/>
              <a:ext cx="1709" cy="313"/>
            </a:xfrm>
            <a:custGeom>
              <a:avLst/>
              <a:gdLst>
                <a:gd name="T0" fmla="*/ 0 w 1709"/>
                <a:gd name="T1" fmla="*/ 0 h 313"/>
                <a:gd name="T2" fmla="*/ 87 w 1709"/>
                <a:gd name="T3" fmla="*/ 0 h 313"/>
                <a:gd name="T4" fmla="*/ 145 w 1709"/>
                <a:gd name="T5" fmla="*/ 0 h 313"/>
                <a:gd name="T6" fmla="*/ 145 w 1709"/>
                <a:gd name="T7" fmla="*/ 9 h 313"/>
                <a:gd name="T8" fmla="*/ 174 w 1709"/>
                <a:gd name="T9" fmla="*/ 9 h 313"/>
                <a:gd name="T10" fmla="*/ 174 w 1709"/>
                <a:gd name="T11" fmla="*/ 24 h 313"/>
                <a:gd name="T12" fmla="*/ 203 w 1709"/>
                <a:gd name="T13" fmla="*/ 24 h 313"/>
                <a:gd name="T14" fmla="*/ 203 w 1709"/>
                <a:gd name="T15" fmla="*/ 38 h 313"/>
                <a:gd name="T16" fmla="*/ 265 w 1709"/>
                <a:gd name="T17" fmla="*/ 38 h 313"/>
                <a:gd name="T18" fmla="*/ 328 w 1709"/>
                <a:gd name="T19" fmla="*/ 38 h 313"/>
                <a:gd name="T20" fmla="*/ 328 w 1709"/>
                <a:gd name="T21" fmla="*/ 48 h 313"/>
                <a:gd name="T22" fmla="*/ 332 w 1709"/>
                <a:gd name="T23" fmla="*/ 48 h 313"/>
                <a:gd name="T24" fmla="*/ 332 w 1709"/>
                <a:gd name="T25" fmla="*/ 62 h 313"/>
                <a:gd name="T26" fmla="*/ 357 w 1709"/>
                <a:gd name="T27" fmla="*/ 62 h 313"/>
                <a:gd name="T28" fmla="*/ 357 w 1709"/>
                <a:gd name="T29" fmla="*/ 77 h 313"/>
                <a:gd name="T30" fmla="*/ 414 w 1709"/>
                <a:gd name="T31" fmla="*/ 77 h 313"/>
                <a:gd name="T32" fmla="*/ 472 w 1709"/>
                <a:gd name="T33" fmla="*/ 77 h 313"/>
                <a:gd name="T34" fmla="*/ 472 w 1709"/>
                <a:gd name="T35" fmla="*/ 91 h 313"/>
                <a:gd name="T36" fmla="*/ 568 w 1709"/>
                <a:gd name="T37" fmla="*/ 91 h 313"/>
                <a:gd name="T38" fmla="*/ 568 w 1709"/>
                <a:gd name="T39" fmla="*/ 101 h 313"/>
                <a:gd name="T40" fmla="*/ 626 w 1709"/>
                <a:gd name="T41" fmla="*/ 101 h 313"/>
                <a:gd name="T42" fmla="*/ 626 w 1709"/>
                <a:gd name="T43" fmla="*/ 115 h 313"/>
                <a:gd name="T44" fmla="*/ 674 w 1709"/>
                <a:gd name="T45" fmla="*/ 115 h 313"/>
                <a:gd name="T46" fmla="*/ 674 w 1709"/>
                <a:gd name="T47" fmla="*/ 130 h 313"/>
                <a:gd name="T48" fmla="*/ 722 w 1709"/>
                <a:gd name="T49" fmla="*/ 130 h 313"/>
                <a:gd name="T50" fmla="*/ 722 w 1709"/>
                <a:gd name="T51" fmla="*/ 144 h 313"/>
                <a:gd name="T52" fmla="*/ 727 w 1709"/>
                <a:gd name="T53" fmla="*/ 154 h 313"/>
                <a:gd name="T54" fmla="*/ 770 w 1709"/>
                <a:gd name="T55" fmla="*/ 154 h 313"/>
                <a:gd name="T56" fmla="*/ 770 w 1709"/>
                <a:gd name="T57" fmla="*/ 154 h 313"/>
                <a:gd name="T58" fmla="*/ 780 w 1709"/>
                <a:gd name="T59" fmla="*/ 154 h 313"/>
                <a:gd name="T60" fmla="*/ 780 w 1709"/>
                <a:gd name="T61" fmla="*/ 168 h 313"/>
                <a:gd name="T62" fmla="*/ 953 w 1709"/>
                <a:gd name="T63" fmla="*/ 168 h 313"/>
                <a:gd name="T64" fmla="*/ 953 w 1709"/>
                <a:gd name="T65" fmla="*/ 183 h 313"/>
                <a:gd name="T66" fmla="*/ 1035 w 1709"/>
                <a:gd name="T67" fmla="*/ 183 h 313"/>
                <a:gd name="T68" fmla="*/ 1035 w 1709"/>
                <a:gd name="T69" fmla="*/ 197 h 313"/>
                <a:gd name="T70" fmla="*/ 1040 w 1709"/>
                <a:gd name="T71" fmla="*/ 197 h 313"/>
                <a:gd name="T72" fmla="*/ 1040 w 1709"/>
                <a:gd name="T73" fmla="*/ 211 h 313"/>
                <a:gd name="T74" fmla="*/ 1049 w 1709"/>
                <a:gd name="T75" fmla="*/ 211 h 313"/>
                <a:gd name="T76" fmla="*/ 1049 w 1709"/>
                <a:gd name="T77" fmla="*/ 226 h 313"/>
                <a:gd name="T78" fmla="*/ 1069 w 1709"/>
                <a:gd name="T79" fmla="*/ 226 h 313"/>
                <a:gd name="T80" fmla="*/ 1078 w 1709"/>
                <a:gd name="T81" fmla="*/ 226 h 313"/>
                <a:gd name="T82" fmla="*/ 1126 w 1709"/>
                <a:gd name="T83" fmla="*/ 226 h 313"/>
                <a:gd name="T84" fmla="*/ 1126 w 1709"/>
                <a:gd name="T85" fmla="*/ 240 h 313"/>
                <a:gd name="T86" fmla="*/ 1131 w 1709"/>
                <a:gd name="T87" fmla="*/ 240 h 313"/>
                <a:gd name="T88" fmla="*/ 1141 w 1709"/>
                <a:gd name="T89" fmla="*/ 240 h 313"/>
                <a:gd name="T90" fmla="*/ 1141 w 1709"/>
                <a:gd name="T91" fmla="*/ 250 h 313"/>
                <a:gd name="T92" fmla="*/ 1150 w 1709"/>
                <a:gd name="T93" fmla="*/ 250 h 313"/>
                <a:gd name="T94" fmla="*/ 1150 w 1709"/>
                <a:gd name="T95" fmla="*/ 264 h 313"/>
                <a:gd name="T96" fmla="*/ 1179 w 1709"/>
                <a:gd name="T97" fmla="*/ 264 h 313"/>
                <a:gd name="T98" fmla="*/ 1199 w 1709"/>
                <a:gd name="T99" fmla="*/ 264 h 313"/>
                <a:gd name="T100" fmla="*/ 1199 w 1709"/>
                <a:gd name="T101" fmla="*/ 279 h 313"/>
                <a:gd name="T102" fmla="*/ 1357 w 1709"/>
                <a:gd name="T103" fmla="*/ 279 h 313"/>
                <a:gd name="T104" fmla="*/ 1357 w 1709"/>
                <a:gd name="T105" fmla="*/ 293 h 313"/>
                <a:gd name="T106" fmla="*/ 1487 w 1709"/>
                <a:gd name="T107" fmla="*/ 293 h 313"/>
                <a:gd name="T108" fmla="*/ 1516 w 1709"/>
                <a:gd name="T109" fmla="*/ 293 h 313"/>
                <a:gd name="T110" fmla="*/ 1516 w 1709"/>
                <a:gd name="T111" fmla="*/ 313 h 313"/>
                <a:gd name="T112" fmla="*/ 1709 w 1709"/>
                <a:gd name="T113" fmla="*/ 313 h 3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</a:cxnLst>
              <a:rect l="0" t="0" r="r" b="b"/>
              <a:pathLst>
                <a:path w="1709" h="313">
                  <a:moveTo>
                    <a:pt x="0" y="0"/>
                  </a:moveTo>
                  <a:lnTo>
                    <a:pt x="87" y="0"/>
                  </a:lnTo>
                  <a:lnTo>
                    <a:pt x="145" y="0"/>
                  </a:lnTo>
                  <a:lnTo>
                    <a:pt x="145" y="9"/>
                  </a:lnTo>
                  <a:lnTo>
                    <a:pt x="174" y="9"/>
                  </a:lnTo>
                  <a:lnTo>
                    <a:pt x="174" y="24"/>
                  </a:lnTo>
                  <a:lnTo>
                    <a:pt x="203" y="24"/>
                  </a:lnTo>
                  <a:lnTo>
                    <a:pt x="203" y="38"/>
                  </a:lnTo>
                  <a:lnTo>
                    <a:pt x="265" y="38"/>
                  </a:lnTo>
                  <a:lnTo>
                    <a:pt x="328" y="38"/>
                  </a:lnTo>
                  <a:lnTo>
                    <a:pt x="328" y="48"/>
                  </a:lnTo>
                  <a:lnTo>
                    <a:pt x="332" y="48"/>
                  </a:lnTo>
                  <a:lnTo>
                    <a:pt x="332" y="62"/>
                  </a:lnTo>
                  <a:lnTo>
                    <a:pt x="357" y="62"/>
                  </a:lnTo>
                  <a:lnTo>
                    <a:pt x="357" y="77"/>
                  </a:lnTo>
                  <a:lnTo>
                    <a:pt x="414" y="77"/>
                  </a:lnTo>
                  <a:lnTo>
                    <a:pt x="472" y="77"/>
                  </a:lnTo>
                  <a:lnTo>
                    <a:pt x="472" y="91"/>
                  </a:lnTo>
                  <a:lnTo>
                    <a:pt x="568" y="91"/>
                  </a:lnTo>
                  <a:lnTo>
                    <a:pt x="568" y="101"/>
                  </a:lnTo>
                  <a:lnTo>
                    <a:pt x="626" y="101"/>
                  </a:lnTo>
                  <a:lnTo>
                    <a:pt x="626" y="115"/>
                  </a:lnTo>
                  <a:lnTo>
                    <a:pt x="674" y="115"/>
                  </a:lnTo>
                  <a:lnTo>
                    <a:pt x="674" y="130"/>
                  </a:lnTo>
                  <a:lnTo>
                    <a:pt x="722" y="130"/>
                  </a:lnTo>
                  <a:lnTo>
                    <a:pt x="722" y="144"/>
                  </a:lnTo>
                  <a:lnTo>
                    <a:pt x="727" y="154"/>
                  </a:lnTo>
                  <a:lnTo>
                    <a:pt x="770" y="154"/>
                  </a:lnTo>
                  <a:lnTo>
                    <a:pt x="770" y="154"/>
                  </a:lnTo>
                  <a:lnTo>
                    <a:pt x="780" y="154"/>
                  </a:lnTo>
                  <a:lnTo>
                    <a:pt x="780" y="168"/>
                  </a:lnTo>
                  <a:lnTo>
                    <a:pt x="953" y="168"/>
                  </a:lnTo>
                  <a:lnTo>
                    <a:pt x="953" y="183"/>
                  </a:lnTo>
                  <a:lnTo>
                    <a:pt x="1035" y="183"/>
                  </a:lnTo>
                  <a:lnTo>
                    <a:pt x="1035" y="197"/>
                  </a:lnTo>
                  <a:lnTo>
                    <a:pt x="1040" y="197"/>
                  </a:lnTo>
                  <a:lnTo>
                    <a:pt x="1040" y="211"/>
                  </a:lnTo>
                  <a:lnTo>
                    <a:pt x="1049" y="211"/>
                  </a:lnTo>
                  <a:lnTo>
                    <a:pt x="1049" y="226"/>
                  </a:lnTo>
                  <a:lnTo>
                    <a:pt x="1069" y="226"/>
                  </a:lnTo>
                  <a:lnTo>
                    <a:pt x="1078" y="226"/>
                  </a:lnTo>
                  <a:lnTo>
                    <a:pt x="1126" y="226"/>
                  </a:lnTo>
                  <a:lnTo>
                    <a:pt x="1126" y="240"/>
                  </a:lnTo>
                  <a:lnTo>
                    <a:pt x="1131" y="240"/>
                  </a:lnTo>
                  <a:lnTo>
                    <a:pt x="1141" y="240"/>
                  </a:lnTo>
                  <a:lnTo>
                    <a:pt x="1141" y="250"/>
                  </a:lnTo>
                  <a:lnTo>
                    <a:pt x="1150" y="250"/>
                  </a:lnTo>
                  <a:lnTo>
                    <a:pt x="1150" y="264"/>
                  </a:lnTo>
                  <a:lnTo>
                    <a:pt x="1179" y="264"/>
                  </a:lnTo>
                  <a:lnTo>
                    <a:pt x="1199" y="264"/>
                  </a:lnTo>
                  <a:lnTo>
                    <a:pt x="1199" y="279"/>
                  </a:lnTo>
                  <a:lnTo>
                    <a:pt x="1357" y="279"/>
                  </a:lnTo>
                  <a:lnTo>
                    <a:pt x="1357" y="293"/>
                  </a:lnTo>
                  <a:lnTo>
                    <a:pt x="1487" y="293"/>
                  </a:lnTo>
                  <a:lnTo>
                    <a:pt x="1516" y="293"/>
                  </a:lnTo>
                  <a:lnTo>
                    <a:pt x="1516" y="313"/>
                  </a:lnTo>
                  <a:lnTo>
                    <a:pt x="1709" y="313"/>
                  </a:lnTo>
                </a:path>
              </a:pathLst>
            </a:custGeom>
            <a:noFill/>
            <a:ln w="12700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Freeform 29">
              <a:extLst>
                <a:ext uri="{FF2B5EF4-FFF2-40B4-BE49-F238E27FC236}">
                  <a16:creationId xmlns:a16="http://schemas.microsoft.com/office/drawing/2014/main" id="{D744B091-49BF-4C21-9400-527E0EBBED5D}"/>
                </a:ext>
              </a:extLst>
            </p:cNvPr>
            <p:cNvSpPr>
              <a:spLocks/>
            </p:cNvSpPr>
            <p:nvPr/>
          </p:nvSpPr>
          <p:spPr bwMode="auto">
            <a:xfrm>
              <a:off x="-1752" y="1638"/>
              <a:ext cx="1713" cy="549"/>
            </a:xfrm>
            <a:custGeom>
              <a:avLst/>
              <a:gdLst>
                <a:gd name="T0" fmla="*/ 0 w 1713"/>
                <a:gd name="T1" fmla="*/ 0 h 549"/>
                <a:gd name="T2" fmla="*/ 29 w 1713"/>
                <a:gd name="T3" fmla="*/ 0 h 549"/>
                <a:gd name="T4" fmla="*/ 29 w 1713"/>
                <a:gd name="T5" fmla="*/ 38 h 549"/>
                <a:gd name="T6" fmla="*/ 34 w 1713"/>
                <a:gd name="T7" fmla="*/ 38 h 549"/>
                <a:gd name="T8" fmla="*/ 150 w 1713"/>
                <a:gd name="T9" fmla="*/ 38 h 549"/>
                <a:gd name="T10" fmla="*/ 150 w 1713"/>
                <a:gd name="T11" fmla="*/ 77 h 549"/>
                <a:gd name="T12" fmla="*/ 328 w 1713"/>
                <a:gd name="T13" fmla="*/ 77 h 549"/>
                <a:gd name="T14" fmla="*/ 328 w 1713"/>
                <a:gd name="T15" fmla="*/ 115 h 549"/>
                <a:gd name="T16" fmla="*/ 347 w 1713"/>
                <a:gd name="T17" fmla="*/ 115 h 549"/>
                <a:gd name="T18" fmla="*/ 347 w 1713"/>
                <a:gd name="T19" fmla="*/ 154 h 549"/>
                <a:gd name="T20" fmla="*/ 366 w 1713"/>
                <a:gd name="T21" fmla="*/ 154 h 549"/>
                <a:gd name="T22" fmla="*/ 366 w 1713"/>
                <a:gd name="T23" fmla="*/ 192 h 549"/>
                <a:gd name="T24" fmla="*/ 438 w 1713"/>
                <a:gd name="T25" fmla="*/ 192 h 549"/>
                <a:gd name="T26" fmla="*/ 438 w 1713"/>
                <a:gd name="T27" fmla="*/ 231 h 549"/>
                <a:gd name="T28" fmla="*/ 525 w 1713"/>
                <a:gd name="T29" fmla="*/ 231 h 549"/>
                <a:gd name="T30" fmla="*/ 525 w 1713"/>
                <a:gd name="T31" fmla="*/ 269 h 549"/>
                <a:gd name="T32" fmla="*/ 535 w 1713"/>
                <a:gd name="T33" fmla="*/ 269 h 549"/>
                <a:gd name="T34" fmla="*/ 535 w 1713"/>
                <a:gd name="T35" fmla="*/ 308 h 549"/>
                <a:gd name="T36" fmla="*/ 818 w 1713"/>
                <a:gd name="T37" fmla="*/ 308 h 549"/>
                <a:gd name="T38" fmla="*/ 818 w 1713"/>
                <a:gd name="T39" fmla="*/ 346 h 549"/>
                <a:gd name="T40" fmla="*/ 886 w 1713"/>
                <a:gd name="T41" fmla="*/ 346 h 549"/>
                <a:gd name="T42" fmla="*/ 886 w 1713"/>
                <a:gd name="T43" fmla="*/ 385 h 549"/>
                <a:gd name="T44" fmla="*/ 1102 w 1713"/>
                <a:gd name="T45" fmla="*/ 385 h 549"/>
                <a:gd name="T46" fmla="*/ 1333 w 1713"/>
                <a:gd name="T47" fmla="*/ 385 h 549"/>
                <a:gd name="T48" fmla="*/ 1333 w 1713"/>
                <a:gd name="T49" fmla="*/ 423 h 549"/>
                <a:gd name="T50" fmla="*/ 1338 w 1713"/>
                <a:gd name="T51" fmla="*/ 423 h 549"/>
                <a:gd name="T52" fmla="*/ 1338 w 1713"/>
                <a:gd name="T53" fmla="*/ 467 h 549"/>
                <a:gd name="T54" fmla="*/ 1473 w 1713"/>
                <a:gd name="T55" fmla="*/ 467 h 549"/>
                <a:gd name="T56" fmla="*/ 1473 w 1713"/>
                <a:gd name="T57" fmla="*/ 505 h 549"/>
                <a:gd name="T58" fmla="*/ 1516 w 1713"/>
                <a:gd name="T59" fmla="*/ 505 h 549"/>
                <a:gd name="T60" fmla="*/ 1612 w 1713"/>
                <a:gd name="T61" fmla="*/ 505 h 549"/>
                <a:gd name="T62" fmla="*/ 1612 w 1713"/>
                <a:gd name="T63" fmla="*/ 549 h 549"/>
                <a:gd name="T64" fmla="*/ 1713 w 1713"/>
                <a:gd name="T65" fmla="*/ 549 h 5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713" h="549">
                  <a:moveTo>
                    <a:pt x="0" y="0"/>
                  </a:moveTo>
                  <a:lnTo>
                    <a:pt x="29" y="0"/>
                  </a:lnTo>
                  <a:lnTo>
                    <a:pt x="29" y="38"/>
                  </a:lnTo>
                  <a:lnTo>
                    <a:pt x="34" y="38"/>
                  </a:lnTo>
                  <a:lnTo>
                    <a:pt x="150" y="38"/>
                  </a:lnTo>
                  <a:lnTo>
                    <a:pt x="150" y="77"/>
                  </a:lnTo>
                  <a:lnTo>
                    <a:pt x="328" y="77"/>
                  </a:lnTo>
                  <a:lnTo>
                    <a:pt x="328" y="115"/>
                  </a:lnTo>
                  <a:lnTo>
                    <a:pt x="347" y="115"/>
                  </a:lnTo>
                  <a:lnTo>
                    <a:pt x="347" y="154"/>
                  </a:lnTo>
                  <a:lnTo>
                    <a:pt x="366" y="154"/>
                  </a:lnTo>
                  <a:lnTo>
                    <a:pt x="366" y="192"/>
                  </a:lnTo>
                  <a:lnTo>
                    <a:pt x="438" y="192"/>
                  </a:lnTo>
                  <a:lnTo>
                    <a:pt x="438" y="231"/>
                  </a:lnTo>
                  <a:lnTo>
                    <a:pt x="525" y="231"/>
                  </a:lnTo>
                  <a:lnTo>
                    <a:pt x="525" y="269"/>
                  </a:lnTo>
                  <a:lnTo>
                    <a:pt x="535" y="269"/>
                  </a:lnTo>
                  <a:lnTo>
                    <a:pt x="535" y="308"/>
                  </a:lnTo>
                  <a:lnTo>
                    <a:pt x="818" y="308"/>
                  </a:lnTo>
                  <a:lnTo>
                    <a:pt x="818" y="346"/>
                  </a:lnTo>
                  <a:lnTo>
                    <a:pt x="886" y="346"/>
                  </a:lnTo>
                  <a:lnTo>
                    <a:pt x="886" y="385"/>
                  </a:lnTo>
                  <a:lnTo>
                    <a:pt x="1102" y="385"/>
                  </a:lnTo>
                  <a:lnTo>
                    <a:pt x="1333" y="385"/>
                  </a:lnTo>
                  <a:lnTo>
                    <a:pt x="1333" y="423"/>
                  </a:lnTo>
                  <a:lnTo>
                    <a:pt x="1338" y="423"/>
                  </a:lnTo>
                  <a:lnTo>
                    <a:pt x="1338" y="467"/>
                  </a:lnTo>
                  <a:lnTo>
                    <a:pt x="1473" y="467"/>
                  </a:lnTo>
                  <a:lnTo>
                    <a:pt x="1473" y="505"/>
                  </a:lnTo>
                  <a:lnTo>
                    <a:pt x="1516" y="505"/>
                  </a:lnTo>
                  <a:lnTo>
                    <a:pt x="1612" y="505"/>
                  </a:lnTo>
                  <a:lnTo>
                    <a:pt x="1612" y="549"/>
                  </a:lnTo>
                  <a:lnTo>
                    <a:pt x="1713" y="549"/>
                  </a:lnTo>
                </a:path>
              </a:pathLst>
            </a:custGeom>
            <a:noFill/>
            <a:ln w="12700">
              <a:solidFill>
                <a:schemeClr val="tx1"/>
              </a:solidFill>
              <a:prstDash val="lgDash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Line 30">
              <a:extLst>
                <a:ext uri="{FF2B5EF4-FFF2-40B4-BE49-F238E27FC236}">
                  <a16:creationId xmlns:a16="http://schemas.microsoft.com/office/drawing/2014/main" id="{39656C4F-0C79-40DE-B2BD-15CA4B35BF7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1752" y="1638"/>
              <a:ext cx="0" cy="1156"/>
            </a:xfrm>
            <a:prstGeom prst="line">
              <a:avLst/>
            </a:prstGeom>
            <a:noFill/>
            <a:ln w="793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Line 31">
              <a:extLst>
                <a:ext uri="{FF2B5EF4-FFF2-40B4-BE49-F238E27FC236}">
                  <a16:creationId xmlns:a16="http://schemas.microsoft.com/office/drawing/2014/main" id="{3EA50225-83EA-40CA-A11C-7F4505D23FB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1752" y="2794"/>
              <a:ext cx="1713" cy="0"/>
            </a:xfrm>
            <a:prstGeom prst="line">
              <a:avLst/>
            </a:prstGeom>
            <a:noFill/>
            <a:ln w="793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Line 32">
              <a:extLst>
                <a:ext uri="{FF2B5EF4-FFF2-40B4-BE49-F238E27FC236}">
                  <a16:creationId xmlns:a16="http://schemas.microsoft.com/office/drawing/2014/main" id="{4DCC9267-9E8F-4C26-AB8B-C9436A1531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578" y="2794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Line 33">
              <a:extLst>
                <a:ext uri="{FF2B5EF4-FFF2-40B4-BE49-F238E27FC236}">
                  <a16:creationId xmlns:a16="http://schemas.microsoft.com/office/drawing/2014/main" id="{25CA0216-4206-48E6-A297-F0CF77C27C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237" y="2794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Line 34">
              <a:extLst>
                <a:ext uri="{FF2B5EF4-FFF2-40B4-BE49-F238E27FC236}">
                  <a16:creationId xmlns:a16="http://schemas.microsoft.com/office/drawing/2014/main" id="{4FDE4152-04D5-4C6C-91FA-88F23C3571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895" y="2794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Line 35">
              <a:extLst>
                <a:ext uri="{FF2B5EF4-FFF2-40B4-BE49-F238E27FC236}">
                  <a16:creationId xmlns:a16="http://schemas.microsoft.com/office/drawing/2014/main" id="{839CAD8B-DE3E-4DA9-A87E-5618209733C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553" y="2794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Line 36">
              <a:extLst>
                <a:ext uri="{FF2B5EF4-FFF2-40B4-BE49-F238E27FC236}">
                  <a16:creationId xmlns:a16="http://schemas.microsoft.com/office/drawing/2014/main" id="{EA734AF5-2880-4BCF-ACF9-C2414B37DA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12" y="2794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Line 37">
              <a:extLst>
                <a:ext uri="{FF2B5EF4-FFF2-40B4-BE49-F238E27FC236}">
                  <a16:creationId xmlns:a16="http://schemas.microsoft.com/office/drawing/2014/main" id="{86415D58-23A0-46CF-8C06-14674ACF918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752" y="2794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Line 38">
              <a:extLst>
                <a:ext uri="{FF2B5EF4-FFF2-40B4-BE49-F238E27FC236}">
                  <a16:creationId xmlns:a16="http://schemas.microsoft.com/office/drawing/2014/main" id="{2875397F-EDF3-4089-B579-51897C5A76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410" y="2794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Line 39">
              <a:extLst>
                <a:ext uri="{FF2B5EF4-FFF2-40B4-BE49-F238E27FC236}">
                  <a16:creationId xmlns:a16="http://schemas.microsoft.com/office/drawing/2014/main" id="{65527052-EF22-48A1-985A-426B2B039C4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068" y="2794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Line 40">
              <a:extLst>
                <a:ext uri="{FF2B5EF4-FFF2-40B4-BE49-F238E27FC236}">
                  <a16:creationId xmlns:a16="http://schemas.microsoft.com/office/drawing/2014/main" id="{06367BB6-3BA1-4DC7-B421-02D1781664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722" y="2794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Line 41">
              <a:extLst>
                <a:ext uri="{FF2B5EF4-FFF2-40B4-BE49-F238E27FC236}">
                  <a16:creationId xmlns:a16="http://schemas.microsoft.com/office/drawing/2014/main" id="{586B7618-CD2F-4609-BF8B-001FE5C737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380" y="2794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Line 42">
              <a:extLst>
                <a:ext uri="{FF2B5EF4-FFF2-40B4-BE49-F238E27FC236}">
                  <a16:creationId xmlns:a16="http://schemas.microsoft.com/office/drawing/2014/main" id="{D8752E62-1AC1-4DC1-A12F-166AD2F135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39" y="2794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Rectangle 43">
              <a:extLst>
                <a:ext uri="{FF2B5EF4-FFF2-40B4-BE49-F238E27FC236}">
                  <a16:creationId xmlns:a16="http://schemas.microsoft.com/office/drawing/2014/main" id="{C917754B-686F-4C74-A00E-4CCD4EAC62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771" y="2827"/>
              <a:ext cx="4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8" name="Rectangle 44">
              <a:extLst>
                <a:ext uri="{FF2B5EF4-FFF2-40B4-BE49-F238E27FC236}">
                  <a16:creationId xmlns:a16="http://schemas.microsoft.com/office/drawing/2014/main" id="{FEAEEEFF-A2B4-4F0F-9684-D38AABCC09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463" y="2827"/>
              <a:ext cx="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12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9" name="Rectangle 45">
              <a:extLst>
                <a:ext uri="{FF2B5EF4-FFF2-40B4-BE49-F238E27FC236}">
                  <a16:creationId xmlns:a16="http://schemas.microsoft.com/office/drawing/2014/main" id="{95860BBF-7862-4252-8F37-CA8D4A2D41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121" y="2827"/>
              <a:ext cx="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24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0" name="Rectangle 46">
              <a:extLst>
                <a:ext uri="{FF2B5EF4-FFF2-40B4-BE49-F238E27FC236}">
                  <a16:creationId xmlns:a16="http://schemas.microsoft.com/office/drawing/2014/main" id="{1021B436-2F81-47CA-B397-9D8C70E4FC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789" y="2827"/>
              <a:ext cx="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36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1" name="Rectangle 47">
              <a:extLst>
                <a:ext uri="{FF2B5EF4-FFF2-40B4-BE49-F238E27FC236}">
                  <a16:creationId xmlns:a16="http://schemas.microsoft.com/office/drawing/2014/main" id="{269DEE2A-87D6-407C-977C-800CA9E0F7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448" y="2827"/>
              <a:ext cx="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48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52" name="Rectangle 48">
              <a:extLst>
                <a:ext uri="{FF2B5EF4-FFF2-40B4-BE49-F238E27FC236}">
                  <a16:creationId xmlns:a16="http://schemas.microsoft.com/office/drawing/2014/main" id="{4665E7A8-50B9-439A-A4EA-8676E154DD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30" y="2827"/>
              <a:ext cx="80" cy="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6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53" name="Rectangle 95">
            <a:extLst>
              <a:ext uri="{FF2B5EF4-FFF2-40B4-BE49-F238E27FC236}">
                <a16:creationId xmlns:a16="http://schemas.microsoft.com/office/drawing/2014/main" id="{0F7CE990-E50C-4492-B2C0-92373CC576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85379" y="1878120"/>
            <a:ext cx="110286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900" dirty="0">
                <a:cs typeface="Arial" panose="020B0604020202020204" pitchFamily="34" charset="0"/>
              </a:rPr>
              <a:t>PT Low complication-</a:t>
            </a:r>
            <a:endParaRPr kumimoji="1" lang="ja-JP" altLang="ja-JP" sz="9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54" name="Rectangle 95">
            <a:extLst>
              <a:ext uri="{FF2B5EF4-FFF2-40B4-BE49-F238E27FC236}">
                <a16:creationId xmlns:a16="http://schemas.microsoft.com/office/drawing/2014/main" id="{92AEB769-1868-4687-ABD2-4C844A8F74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58756" y="2109782"/>
            <a:ext cx="115736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900" dirty="0">
                <a:cs typeface="Arial" panose="020B0604020202020204" pitchFamily="34" charset="0"/>
              </a:rPr>
              <a:t>PT High complication+</a:t>
            </a:r>
            <a:endParaRPr kumimoji="1" lang="ja-JP" altLang="ja-JP" sz="9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55" name="Rectangle 95">
            <a:extLst>
              <a:ext uri="{FF2B5EF4-FFF2-40B4-BE49-F238E27FC236}">
                <a16:creationId xmlns:a16="http://schemas.microsoft.com/office/drawing/2014/main" id="{F1190F00-A9B1-4A92-BC1F-DE3FC74F02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31598" y="2557205"/>
            <a:ext cx="11317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900" dirty="0">
                <a:cs typeface="Arial" panose="020B0604020202020204" pitchFamily="34" charset="0"/>
              </a:rPr>
              <a:t>PT Low complication+</a:t>
            </a:r>
            <a:endParaRPr kumimoji="1" lang="ja-JP" altLang="ja-JP" sz="9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grpSp>
        <p:nvGrpSpPr>
          <p:cNvPr id="56" name="Group 52">
            <a:extLst>
              <a:ext uri="{FF2B5EF4-FFF2-40B4-BE49-F238E27FC236}">
                <a16:creationId xmlns:a16="http://schemas.microsoft.com/office/drawing/2014/main" id="{5A9490EE-842F-4D3A-8520-45CB1301F77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4416191" y="1453700"/>
            <a:ext cx="4283440" cy="2772000"/>
            <a:chOff x="-2569" y="1222"/>
            <a:chExt cx="2083" cy="1348"/>
          </a:xfrm>
        </p:grpSpPr>
        <p:sp>
          <p:nvSpPr>
            <p:cNvPr id="57" name="Rectangle 53">
              <a:extLst>
                <a:ext uri="{FF2B5EF4-FFF2-40B4-BE49-F238E27FC236}">
                  <a16:creationId xmlns:a16="http://schemas.microsoft.com/office/drawing/2014/main" id="{72020D40-63CD-45C2-B7BB-EB8F24DA97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569" y="1227"/>
              <a:ext cx="5" cy="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Rectangle 54">
              <a:extLst>
                <a:ext uri="{FF2B5EF4-FFF2-40B4-BE49-F238E27FC236}">
                  <a16:creationId xmlns:a16="http://schemas.microsoft.com/office/drawing/2014/main" id="{0970127A-13BF-4B53-9E44-831643F0A1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569" y="1227"/>
              <a:ext cx="5" cy="5"/>
            </a:xfrm>
            <a:prstGeom prst="rect">
              <a:avLst/>
            </a:prstGeom>
            <a:solidFill>
              <a:srgbClr val="F8F8F8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Line 55">
              <a:extLst>
                <a:ext uri="{FF2B5EF4-FFF2-40B4-BE49-F238E27FC236}">
                  <a16:creationId xmlns:a16="http://schemas.microsoft.com/office/drawing/2014/main" id="{96809620-E88C-4964-8679-1E971855ED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13" y="2305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Line 56">
              <a:extLst>
                <a:ext uri="{FF2B5EF4-FFF2-40B4-BE49-F238E27FC236}">
                  <a16:creationId xmlns:a16="http://schemas.microsoft.com/office/drawing/2014/main" id="{F601890C-4248-4137-8AD4-67AC42C75B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13" y="2074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Line 57">
              <a:extLst>
                <a:ext uri="{FF2B5EF4-FFF2-40B4-BE49-F238E27FC236}">
                  <a16:creationId xmlns:a16="http://schemas.microsoft.com/office/drawing/2014/main" id="{B7B0E8E8-D7CD-48F4-885D-D047248EE3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13" y="1843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Line 58">
              <a:extLst>
                <a:ext uri="{FF2B5EF4-FFF2-40B4-BE49-F238E27FC236}">
                  <a16:creationId xmlns:a16="http://schemas.microsoft.com/office/drawing/2014/main" id="{31D4B920-6C00-47CF-8AEC-4856175AE5B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13" y="1612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Line 59">
              <a:extLst>
                <a:ext uri="{FF2B5EF4-FFF2-40B4-BE49-F238E27FC236}">
                  <a16:creationId xmlns:a16="http://schemas.microsoft.com/office/drawing/2014/main" id="{C5B188F8-FE33-45E1-996F-D07572E2BD5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13" y="1381"/>
              <a:ext cx="14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Line 60">
              <a:extLst>
                <a:ext uri="{FF2B5EF4-FFF2-40B4-BE49-F238E27FC236}">
                  <a16:creationId xmlns:a16="http://schemas.microsoft.com/office/drawing/2014/main" id="{F1E07754-7E84-4E02-8CF0-AB21DAECF24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27" y="2421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Line 61">
              <a:extLst>
                <a:ext uri="{FF2B5EF4-FFF2-40B4-BE49-F238E27FC236}">
                  <a16:creationId xmlns:a16="http://schemas.microsoft.com/office/drawing/2014/main" id="{728B3BD1-C9A4-48EA-9C2B-AF9CF40B317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27" y="2190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Line 62">
              <a:extLst>
                <a:ext uri="{FF2B5EF4-FFF2-40B4-BE49-F238E27FC236}">
                  <a16:creationId xmlns:a16="http://schemas.microsoft.com/office/drawing/2014/main" id="{7037BC72-3B41-49D7-832E-DC6DC6004B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27" y="1959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Line 63">
              <a:extLst>
                <a:ext uri="{FF2B5EF4-FFF2-40B4-BE49-F238E27FC236}">
                  <a16:creationId xmlns:a16="http://schemas.microsoft.com/office/drawing/2014/main" id="{AD032AD7-F802-4C39-9E33-2E28D0B979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27" y="1728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Line 64">
              <a:extLst>
                <a:ext uri="{FF2B5EF4-FFF2-40B4-BE49-F238E27FC236}">
                  <a16:creationId xmlns:a16="http://schemas.microsoft.com/office/drawing/2014/main" id="{5DE27BD8-2FA0-4766-BF89-B4E5EF368D4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27" y="1497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Line 65">
              <a:extLst>
                <a:ext uri="{FF2B5EF4-FFF2-40B4-BE49-F238E27FC236}">
                  <a16:creationId xmlns:a16="http://schemas.microsoft.com/office/drawing/2014/main" id="{1F206B21-56F2-41B5-B8B3-AAAF9674BF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227" y="1266"/>
              <a:ext cx="28" cy="0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Rectangle 66">
              <a:extLst>
                <a:ext uri="{FF2B5EF4-FFF2-40B4-BE49-F238E27FC236}">
                  <a16:creationId xmlns:a16="http://schemas.microsoft.com/office/drawing/2014/main" id="{80BC82A2-07BC-4221-89FE-F74DA78526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275" y="2377"/>
              <a:ext cx="5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1" name="Rectangle 67">
              <a:extLst>
                <a:ext uri="{FF2B5EF4-FFF2-40B4-BE49-F238E27FC236}">
                  <a16:creationId xmlns:a16="http://schemas.microsoft.com/office/drawing/2014/main" id="{7CCD3A4A-EA57-4D65-AD61-125D8C144F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328" y="2146"/>
              <a:ext cx="1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.2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2" name="Rectangle 68">
              <a:extLst>
                <a:ext uri="{FF2B5EF4-FFF2-40B4-BE49-F238E27FC236}">
                  <a16:creationId xmlns:a16="http://schemas.microsoft.com/office/drawing/2014/main" id="{74AC1210-14D2-483E-B1E7-F6A25ECAA2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328" y="1915"/>
              <a:ext cx="1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.4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3" name="Rectangle 69">
              <a:extLst>
                <a:ext uri="{FF2B5EF4-FFF2-40B4-BE49-F238E27FC236}">
                  <a16:creationId xmlns:a16="http://schemas.microsoft.com/office/drawing/2014/main" id="{AD850D76-43AF-454F-A100-89F934C1E2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328" y="1684"/>
              <a:ext cx="1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.6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4" name="Rectangle 70">
              <a:extLst>
                <a:ext uri="{FF2B5EF4-FFF2-40B4-BE49-F238E27FC236}">
                  <a16:creationId xmlns:a16="http://schemas.microsoft.com/office/drawing/2014/main" id="{522C80D6-7671-4E8A-9721-B6D8193BE8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328" y="1453"/>
              <a:ext cx="1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.8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5" name="Rectangle 71">
              <a:extLst>
                <a:ext uri="{FF2B5EF4-FFF2-40B4-BE49-F238E27FC236}">
                  <a16:creationId xmlns:a16="http://schemas.microsoft.com/office/drawing/2014/main" id="{2AE96B76-8B06-445A-89B8-42549EA2EC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328" y="1222"/>
              <a:ext cx="13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1.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" name="Freeform 74">
              <a:extLst>
                <a:ext uri="{FF2B5EF4-FFF2-40B4-BE49-F238E27FC236}">
                  <a16:creationId xmlns:a16="http://schemas.microsoft.com/office/drawing/2014/main" id="{C9D54914-F457-4CA5-BE4E-004E1453EABE}"/>
                </a:ext>
              </a:extLst>
            </p:cNvPr>
            <p:cNvSpPr>
              <a:spLocks/>
            </p:cNvSpPr>
            <p:nvPr/>
          </p:nvSpPr>
          <p:spPr bwMode="auto">
            <a:xfrm>
              <a:off x="-2199" y="1266"/>
              <a:ext cx="1713" cy="91"/>
            </a:xfrm>
            <a:custGeom>
              <a:avLst/>
              <a:gdLst>
                <a:gd name="T0" fmla="*/ 0 w 1713"/>
                <a:gd name="T1" fmla="*/ 0 h 91"/>
                <a:gd name="T2" fmla="*/ 15 w 1713"/>
                <a:gd name="T3" fmla="*/ 0 h 91"/>
                <a:gd name="T4" fmla="*/ 227 w 1713"/>
                <a:gd name="T5" fmla="*/ 0 h 91"/>
                <a:gd name="T6" fmla="*/ 366 w 1713"/>
                <a:gd name="T7" fmla="*/ 0 h 91"/>
                <a:gd name="T8" fmla="*/ 429 w 1713"/>
                <a:gd name="T9" fmla="*/ 0 h 91"/>
                <a:gd name="T10" fmla="*/ 429 w 1713"/>
                <a:gd name="T11" fmla="*/ 14 h 91"/>
                <a:gd name="T12" fmla="*/ 443 w 1713"/>
                <a:gd name="T13" fmla="*/ 14 h 91"/>
                <a:gd name="T14" fmla="*/ 443 w 1713"/>
                <a:gd name="T15" fmla="*/ 24 h 91"/>
                <a:gd name="T16" fmla="*/ 486 w 1713"/>
                <a:gd name="T17" fmla="*/ 24 h 91"/>
                <a:gd name="T18" fmla="*/ 486 w 1713"/>
                <a:gd name="T19" fmla="*/ 38 h 91"/>
                <a:gd name="T20" fmla="*/ 515 w 1713"/>
                <a:gd name="T21" fmla="*/ 38 h 91"/>
                <a:gd name="T22" fmla="*/ 592 w 1713"/>
                <a:gd name="T23" fmla="*/ 38 h 91"/>
                <a:gd name="T24" fmla="*/ 592 w 1713"/>
                <a:gd name="T25" fmla="*/ 52 h 91"/>
                <a:gd name="T26" fmla="*/ 770 w 1713"/>
                <a:gd name="T27" fmla="*/ 52 h 91"/>
                <a:gd name="T28" fmla="*/ 770 w 1713"/>
                <a:gd name="T29" fmla="*/ 62 h 91"/>
                <a:gd name="T30" fmla="*/ 905 w 1713"/>
                <a:gd name="T31" fmla="*/ 62 h 91"/>
                <a:gd name="T32" fmla="*/ 905 w 1713"/>
                <a:gd name="T33" fmla="*/ 77 h 91"/>
                <a:gd name="T34" fmla="*/ 982 w 1713"/>
                <a:gd name="T35" fmla="*/ 77 h 91"/>
                <a:gd name="T36" fmla="*/ 982 w 1713"/>
                <a:gd name="T37" fmla="*/ 91 h 91"/>
                <a:gd name="T38" fmla="*/ 1030 w 1713"/>
                <a:gd name="T39" fmla="*/ 91 h 91"/>
                <a:gd name="T40" fmla="*/ 1102 w 1713"/>
                <a:gd name="T41" fmla="*/ 91 h 91"/>
                <a:gd name="T42" fmla="*/ 1290 w 1713"/>
                <a:gd name="T43" fmla="*/ 91 h 91"/>
                <a:gd name="T44" fmla="*/ 1348 w 1713"/>
                <a:gd name="T45" fmla="*/ 91 h 91"/>
                <a:gd name="T46" fmla="*/ 1405 w 1713"/>
                <a:gd name="T47" fmla="*/ 91 h 91"/>
                <a:gd name="T48" fmla="*/ 1608 w 1713"/>
                <a:gd name="T49" fmla="*/ 91 h 91"/>
                <a:gd name="T50" fmla="*/ 1713 w 1713"/>
                <a:gd name="T51" fmla="*/ 91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1713" h="91">
                  <a:moveTo>
                    <a:pt x="0" y="0"/>
                  </a:moveTo>
                  <a:lnTo>
                    <a:pt x="15" y="0"/>
                  </a:lnTo>
                  <a:lnTo>
                    <a:pt x="227" y="0"/>
                  </a:lnTo>
                  <a:lnTo>
                    <a:pt x="366" y="0"/>
                  </a:lnTo>
                  <a:lnTo>
                    <a:pt x="429" y="0"/>
                  </a:lnTo>
                  <a:lnTo>
                    <a:pt x="429" y="14"/>
                  </a:lnTo>
                  <a:lnTo>
                    <a:pt x="443" y="14"/>
                  </a:lnTo>
                  <a:lnTo>
                    <a:pt x="443" y="24"/>
                  </a:lnTo>
                  <a:lnTo>
                    <a:pt x="486" y="24"/>
                  </a:lnTo>
                  <a:lnTo>
                    <a:pt x="486" y="38"/>
                  </a:lnTo>
                  <a:lnTo>
                    <a:pt x="515" y="38"/>
                  </a:lnTo>
                  <a:lnTo>
                    <a:pt x="592" y="38"/>
                  </a:lnTo>
                  <a:lnTo>
                    <a:pt x="592" y="52"/>
                  </a:lnTo>
                  <a:lnTo>
                    <a:pt x="770" y="52"/>
                  </a:lnTo>
                  <a:lnTo>
                    <a:pt x="770" y="62"/>
                  </a:lnTo>
                  <a:lnTo>
                    <a:pt x="905" y="62"/>
                  </a:lnTo>
                  <a:lnTo>
                    <a:pt x="905" y="77"/>
                  </a:lnTo>
                  <a:lnTo>
                    <a:pt x="982" y="77"/>
                  </a:lnTo>
                  <a:lnTo>
                    <a:pt x="982" y="91"/>
                  </a:lnTo>
                  <a:lnTo>
                    <a:pt x="1030" y="91"/>
                  </a:lnTo>
                  <a:lnTo>
                    <a:pt x="1102" y="91"/>
                  </a:lnTo>
                  <a:lnTo>
                    <a:pt x="1290" y="91"/>
                  </a:lnTo>
                  <a:lnTo>
                    <a:pt x="1348" y="91"/>
                  </a:lnTo>
                  <a:lnTo>
                    <a:pt x="1405" y="91"/>
                  </a:lnTo>
                  <a:lnTo>
                    <a:pt x="1608" y="91"/>
                  </a:lnTo>
                  <a:lnTo>
                    <a:pt x="1713" y="91"/>
                  </a:lnTo>
                </a:path>
              </a:pathLst>
            </a:cu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Freeform 75">
              <a:extLst>
                <a:ext uri="{FF2B5EF4-FFF2-40B4-BE49-F238E27FC236}">
                  <a16:creationId xmlns:a16="http://schemas.microsoft.com/office/drawing/2014/main" id="{EAB9A1A4-5624-4013-A0F5-5B9AC4A68A73}"/>
                </a:ext>
              </a:extLst>
            </p:cNvPr>
            <p:cNvSpPr>
              <a:spLocks/>
            </p:cNvSpPr>
            <p:nvPr/>
          </p:nvSpPr>
          <p:spPr bwMode="auto">
            <a:xfrm>
              <a:off x="-2199" y="1266"/>
              <a:ext cx="1713" cy="178"/>
            </a:xfrm>
            <a:custGeom>
              <a:avLst/>
              <a:gdLst>
                <a:gd name="T0" fmla="*/ 0 w 1713"/>
                <a:gd name="T1" fmla="*/ 0 h 178"/>
                <a:gd name="T2" fmla="*/ 443 w 1713"/>
                <a:gd name="T3" fmla="*/ 0 h 178"/>
                <a:gd name="T4" fmla="*/ 448 w 1713"/>
                <a:gd name="T5" fmla="*/ 0 h 178"/>
                <a:gd name="T6" fmla="*/ 448 w 1713"/>
                <a:gd name="T7" fmla="*/ 43 h 178"/>
                <a:gd name="T8" fmla="*/ 520 w 1713"/>
                <a:gd name="T9" fmla="*/ 43 h 178"/>
                <a:gd name="T10" fmla="*/ 520 w 1713"/>
                <a:gd name="T11" fmla="*/ 91 h 178"/>
                <a:gd name="T12" fmla="*/ 544 w 1713"/>
                <a:gd name="T13" fmla="*/ 91 h 178"/>
                <a:gd name="T14" fmla="*/ 544 w 1713"/>
                <a:gd name="T15" fmla="*/ 134 h 178"/>
                <a:gd name="T16" fmla="*/ 578 w 1713"/>
                <a:gd name="T17" fmla="*/ 134 h 178"/>
                <a:gd name="T18" fmla="*/ 578 w 1713"/>
                <a:gd name="T19" fmla="*/ 178 h 178"/>
                <a:gd name="T20" fmla="*/ 867 w 1713"/>
                <a:gd name="T21" fmla="*/ 178 h 178"/>
                <a:gd name="T22" fmla="*/ 1102 w 1713"/>
                <a:gd name="T23" fmla="*/ 178 h 178"/>
                <a:gd name="T24" fmla="*/ 1646 w 1713"/>
                <a:gd name="T25" fmla="*/ 178 h 178"/>
                <a:gd name="T26" fmla="*/ 1713 w 1713"/>
                <a:gd name="T27" fmla="*/ 178 h 17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713" h="178">
                  <a:moveTo>
                    <a:pt x="0" y="0"/>
                  </a:moveTo>
                  <a:lnTo>
                    <a:pt x="443" y="0"/>
                  </a:lnTo>
                  <a:lnTo>
                    <a:pt x="448" y="0"/>
                  </a:lnTo>
                  <a:lnTo>
                    <a:pt x="448" y="43"/>
                  </a:lnTo>
                  <a:lnTo>
                    <a:pt x="520" y="43"/>
                  </a:lnTo>
                  <a:lnTo>
                    <a:pt x="520" y="91"/>
                  </a:lnTo>
                  <a:lnTo>
                    <a:pt x="544" y="91"/>
                  </a:lnTo>
                  <a:lnTo>
                    <a:pt x="544" y="134"/>
                  </a:lnTo>
                  <a:lnTo>
                    <a:pt x="578" y="134"/>
                  </a:lnTo>
                  <a:lnTo>
                    <a:pt x="578" y="178"/>
                  </a:lnTo>
                  <a:lnTo>
                    <a:pt x="867" y="178"/>
                  </a:lnTo>
                  <a:lnTo>
                    <a:pt x="1102" y="178"/>
                  </a:lnTo>
                  <a:lnTo>
                    <a:pt x="1646" y="178"/>
                  </a:lnTo>
                  <a:lnTo>
                    <a:pt x="1713" y="178"/>
                  </a:lnTo>
                </a:path>
              </a:pathLst>
            </a:custGeom>
            <a:noFill/>
            <a:ln w="12700">
              <a:solidFill>
                <a:schemeClr val="tx1"/>
              </a:solidFill>
              <a:prstDash val="sys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Freeform 76">
              <a:extLst>
                <a:ext uri="{FF2B5EF4-FFF2-40B4-BE49-F238E27FC236}">
                  <a16:creationId xmlns:a16="http://schemas.microsoft.com/office/drawing/2014/main" id="{A72370B9-860C-4B89-926A-34CF060D5D47}"/>
                </a:ext>
              </a:extLst>
            </p:cNvPr>
            <p:cNvSpPr>
              <a:spLocks/>
            </p:cNvSpPr>
            <p:nvPr/>
          </p:nvSpPr>
          <p:spPr bwMode="auto">
            <a:xfrm>
              <a:off x="-2199" y="1266"/>
              <a:ext cx="1713" cy="173"/>
            </a:xfrm>
            <a:custGeom>
              <a:avLst/>
              <a:gdLst>
                <a:gd name="T0" fmla="*/ 0 w 1713"/>
                <a:gd name="T1" fmla="*/ 0 h 173"/>
                <a:gd name="T2" fmla="*/ 284 w 1713"/>
                <a:gd name="T3" fmla="*/ 0 h 173"/>
                <a:gd name="T4" fmla="*/ 357 w 1713"/>
                <a:gd name="T5" fmla="*/ 0 h 173"/>
                <a:gd name="T6" fmla="*/ 357 w 1713"/>
                <a:gd name="T7" fmla="*/ 14 h 173"/>
                <a:gd name="T8" fmla="*/ 357 w 1713"/>
                <a:gd name="T9" fmla="*/ 14 h 173"/>
                <a:gd name="T10" fmla="*/ 357 w 1713"/>
                <a:gd name="T11" fmla="*/ 28 h 173"/>
                <a:gd name="T12" fmla="*/ 448 w 1713"/>
                <a:gd name="T13" fmla="*/ 28 h 173"/>
                <a:gd name="T14" fmla="*/ 448 w 1713"/>
                <a:gd name="T15" fmla="*/ 43 h 173"/>
                <a:gd name="T16" fmla="*/ 669 w 1713"/>
                <a:gd name="T17" fmla="*/ 43 h 173"/>
                <a:gd name="T18" fmla="*/ 669 w 1713"/>
                <a:gd name="T19" fmla="*/ 62 h 173"/>
                <a:gd name="T20" fmla="*/ 717 w 1713"/>
                <a:gd name="T21" fmla="*/ 62 h 173"/>
                <a:gd name="T22" fmla="*/ 775 w 1713"/>
                <a:gd name="T23" fmla="*/ 62 h 173"/>
                <a:gd name="T24" fmla="*/ 775 w 1713"/>
                <a:gd name="T25" fmla="*/ 77 h 173"/>
                <a:gd name="T26" fmla="*/ 775 w 1713"/>
                <a:gd name="T27" fmla="*/ 91 h 173"/>
                <a:gd name="T28" fmla="*/ 780 w 1713"/>
                <a:gd name="T29" fmla="*/ 91 h 173"/>
                <a:gd name="T30" fmla="*/ 843 w 1713"/>
                <a:gd name="T31" fmla="*/ 91 h 173"/>
                <a:gd name="T32" fmla="*/ 843 w 1713"/>
                <a:gd name="T33" fmla="*/ 105 h 173"/>
                <a:gd name="T34" fmla="*/ 881 w 1713"/>
                <a:gd name="T35" fmla="*/ 105 h 173"/>
                <a:gd name="T36" fmla="*/ 881 w 1713"/>
                <a:gd name="T37" fmla="*/ 125 h 173"/>
                <a:gd name="T38" fmla="*/ 895 w 1713"/>
                <a:gd name="T39" fmla="*/ 125 h 173"/>
                <a:gd name="T40" fmla="*/ 968 w 1713"/>
                <a:gd name="T41" fmla="*/ 125 h 173"/>
                <a:gd name="T42" fmla="*/ 1227 w 1713"/>
                <a:gd name="T43" fmla="*/ 125 h 173"/>
                <a:gd name="T44" fmla="*/ 1227 w 1713"/>
                <a:gd name="T45" fmla="*/ 139 h 173"/>
                <a:gd name="T46" fmla="*/ 1391 w 1713"/>
                <a:gd name="T47" fmla="*/ 139 h 173"/>
                <a:gd name="T48" fmla="*/ 1391 w 1713"/>
                <a:gd name="T49" fmla="*/ 158 h 173"/>
                <a:gd name="T50" fmla="*/ 1454 w 1713"/>
                <a:gd name="T51" fmla="*/ 158 h 173"/>
                <a:gd name="T52" fmla="*/ 1454 w 1713"/>
                <a:gd name="T53" fmla="*/ 173 h 173"/>
                <a:gd name="T54" fmla="*/ 1641 w 1713"/>
                <a:gd name="T55" fmla="*/ 173 h 173"/>
                <a:gd name="T56" fmla="*/ 1646 w 1713"/>
                <a:gd name="T57" fmla="*/ 173 h 173"/>
                <a:gd name="T58" fmla="*/ 1689 w 1713"/>
                <a:gd name="T59" fmla="*/ 173 h 173"/>
                <a:gd name="T60" fmla="*/ 1699 w 1713"/>
                <a:gd name="T61" fmla="*/ 173 h 173"/>
                <a:gd name="T62" fmla="*/ 1709 w 1713"/>
                <a:gd name="T63" fmla="*/ 173 h 173"/>
                <a:gd name="T64" fmla="*/ 1713 w 1713"/>
                <a:gd name="T65" fmla="*/ 173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</a:cxnLst>
              <a:rect l="0" t="0" r="r" b="b"/>
              <a:pathLst>
                <a:path w="1713" h="173">
                  <a:moveTo>
                    <a:pt x="0" y="0"/>
                  </a:moveTo>
                  <a:lnTo>
                    <a:pt x="284" y="0"/>
                  </a:lnTo>
                  <a:lnTo>
                    <a:pt x="357" y="0"/>
                  </a:lnTo>
                  <a:lnTo>
                    <a:pt x="357" y="14"/>
                  </a:lnTo>
                  <a:lnTo>
                    <a:pt x="357" y="14"/>
                  </a:lnTo>
                  <a:lnTo>
                    <a:pt x="357" y="28"/>
                  </a:lnTo>
                  <a:lnTo>
                    <a:pt x="448" y="28"/>
                  </a:lnTo>
                  <a:lnTo>
                    <a:pt x="448" y="43"/>
                  </a:lnTo>
                  <a:lnTo>
                    <a:pt x="669" y="43"/>
                  </a:lnTo>
                  <a:lnTo>
                    <a:pt x="669" y="62"/>
                  </a:lnTo>
                  <a:lnTo>
                    <a:pt x="717" y="62"/>
                  </a:lnTo>
                  <a:lnTo>
                    <a:pt x="775" y="62"/>
                  </a:lnTo>
                  <a:lnTo>
                    <a:pt x="775" y="77"/>
                  </a:lnTo>
                  <a:lnTo>
                    <a:pt x="775" y="91"/>
                  </a:lnTo>
                  <a:lnTo>
                    <a:pt x="780" y="91"/>
                  </a:lnTo>
                  <a:lnTo>
                    <a:pt x="843" y="91"/>
                  </a:lnTo>
                  <a:lnTo>
                    <a:pt x="843" y="105"/>
                  </a:lnTo>
                  <a:lnTo>
                    <a:pt x="881" y="105"/>
                  </a:lnTo>
                  <a:lnTo>
                    <a:pt x="881" y="125"/>
                  </a:lnTo>
                  <a:lnTo>
                    <a:pt x="895" y="125"/>
                  </a:lnTo>
                  <a:lnTo>
                    <a:pt x="968" y="125"/>
                  </a:lnTo>
                  <a:lnTo>
                    <a:pt x="1227" y="125"/>
                  </a:lnTo>
                  <a:lnTo>
                    <a:pt x="1227" y="139"/>
                  </a:lnTo>
                  <a:lnTo>
                    <a:pt x="1391" y="139"/>
                  </a:lnTo>
                  <a:lnTo>
                    <a:pt x="1391" y="158"/>
                  </a:lnTo>
                  <a:lnTo>
                    <a:pt x="1454" y="158"/>
                  </a:lnTo>
                  <a:lnTo>
                    <a:pt x="1454" y="173"/>
                  </a:lnTo>
                  <a:lnTo>
                    <a:pt x="1641" y="173"/>
                  </a:lnTo>
                  <a:lnTo>
                    <a:pt x="1646" y="173"/>
                  </a:lnTo>
                  <a:lnTo>
                    <a:pt x="1689" y="173"/>
                  </a:lnTo>
                  <a:lnTo>
                    <a:pt x="1699" y="173"/>
                  </a:lnTo>
                  <a:lnTo>
                    <a:pt x="1709" y="173"/>
                  </a:lnTo>
                  <a:lnTo>
                    <a:pt x="1713" y="173"/>
                  </a:lnTo>
                </a:path>
              </a:pathLst>
            </a:custGeom>
            <a:noFill/>
            <a:ln w="12700">
              <a:solidFill>
                <a:schemeClr val="tx1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Freeform 77">
              <a:extLst>
                <a:ext uri="{FF2B5EF4-FFF2-40B4-BE49-F238E27FC236}">
                  <a16:creationId xmlns:a16="http://schemas.microsoft.com/office/drawing/2014/main" id="{73A70946-84B6-4F45-9F5E-B08BA7BFE0E7}"/>
                </a:ext>
              </a:extLst>
            </p:cNvPr>
            <p:cNvSpPr>
              <a:spLocks/>
            </p:cNvSpPr>
            <p:nvPr/>
          </p:nvSpPr>
          <p:spPr bwMode="auto">
            <a:xfrm>
              <a:off x="-2199" y="1266"/>
              <a:ext cx="1713" cy="476"/>
            </a:xfrm>
            <a:custGeom>
              <a:avLst/>
              <a:gdLst>
                <a:gd name="T0" fmla="*/ 0 w 1713"/>
                <a:gd name="T1" fmla="*/ 0 h 476"/>
                <a:gd name="T2" fmla="*/ 0 w 1713"/>
                <a:gd name="T3" fmla="*/ 0 h 476"/>
                <a:gd name="T4" fmla="*/ 0 w 1713"/>
                <a:gd name="T5" fmla="*/ 24 h 476"/>
                <a:gd name="T6" fmla="*/ 130 w 1713"/>
                <a:gd name="T7" fmla="*/ 24 h 476"/>
                <a:gd name="T8" fmla="*/ 130 w 1713"/>
                <a:gd name="T9" fmla="*/ 48 h 476"/>
                <a:gd name="T10" fmla="*/ 150 w 1713"/>
                <a:gd name="T11" fmla="*/ 48 h 476"/>
                <a:gd name="T12" fmla="*/ 188 w 1713"/>
                <a:gd name="T13" fmla="*/ 48 h 476"/>
                <a:gd name="T14" fmla="*/ 188 w 1713"/>
                <a:gd name="T15" fmla="*/ 72 h 476"/>
                <a:gd name="T16" fmla="*/ 304 w 1713"/>
                <a:gd name="T17" fmla="*/ 72 h 476"/>
                <a:gd name="T18" fmla="*/ 304 w 1713"/>
                <a:gd name="T19" fmla="*/ 96 h 476"/>
                <a:gd name="T20" fmla="*/ 308 w 1713"/>
                <a:gd name="T21" fmla="*/ 120 h 476"/>
                <a:gd name="T22" fmla="*/ 434 w 1713"/>
                <a:gd name="T23" fmla="*/ 120 h 476"/>
                <a:gd name="T24" fmla="*/ 434 w 1713"/>
                <a:gd name="T25" fmla="*/ 149 h 476"/>
                <a:gd name="T26" fmla="*/ 458 w 1713"/>
                <a:gd name="T27" fmla="*/ 149 h 476"/>
                <a:gd name="T28" fmla="*/ 563 w 1713"/>
                <a:gd name="T29" fmla="*/ 149 h 476"/>
                <a:gd name="T30" fmla="*/ 563 w 1713"/>
                <a:gd name="T31" fmla="*/ 173 h 476"/>
                <a:gd name="T32" fmla="*/ 583 w 1713"/>
                <a:gd name="T33" fmla="*/ 173 h 476"/>
                <a:gd name="T34" fmla="*/ 592 w 1713"/>
                <a:gd name="T35" fmla="*/ 173 h 476"/>
                <a:gd name="T36" fmla="*/ 592 w 1713"/>
                <a:gd name="T37" fmla="*/ 202 h 476"/>
                <a:gd name="T38" fmla="*/ 592 w 1713"/>
                <a:gd name="T39" fmla="*/ 226 h 476"/>
                <a:gd name="T40" fmla="*/ 660 w 1713"/>
                <a:gd name="T41" fmla="*/ 226 h 476"/>
                <a:gd name="T42" fmla="*/ 660 w 1713"/>
                <a:gd name="T43" fmla="*/ 255 h 476"/>
                <a:gd name="T44" fmla="*/ 910 w 1713"/>
                <a:gd name="T45" fmla="*/ 255 h 476"/>
                <a:gd name="T46" fmla="*/ 919 w 1713"/>
                <a:gd name="T47" fmla="*/ 255 h 476"/>
                <a:gd name="T48" fmla="*/ 919 w 1713"/>
                <a:gd name="T49" fmla="*/ 279 h 476"/>
                <a:gd name="T50" fmla="*/ 934 w 1713"/>
                <a:gd name="T51" fmla="*/ 279 h 476"/>
                <a:gd name="T52" fmla="*/ 934 w 1713"/>
                <a:gd name="T53" fmla="*/ 308 h 476"/>
                <a:gd name="T54" fmla="*/ 1040 w 1713"/>
                <a:gd name="T55" fmla="*/ 308 h 476"/>
                <a:gd name="T56" fmla="*/ 1049 w 1713"/>
                <a:gd name="T57" fmla="*/ 308 h 476"/>
                <a:gd name="T58" fmla="*/ 1049 w 1713"/>
                <a:gd name="T59" fmla="*/ 336 h 476"/>
                <a:gd name="T60" fmla="*/ 1073 w 1713"/>
                <a:gd name="T61" fmla="*/ 336 h 476"/>
                <a:gd name="T62" fmla="*/ 1073 w 1713"/>
                <a:gd name="T63" fmla="*/ 365 h 476"/>
                <a:gd name="T64" fmla="*/ 1083 w 1713"/>
                <a:gd name="T65" fmla="*/ 365 h 476"/>
                <a:gd name="T66" fmla="*/ 1083 w 1713"/>
                <a:gd name="T67" fmla="*/ 389 h 476"/>
                <a:gd name="T68" fmla="*/ 1098 w 1713"/>
                <a:gd name="T69" fmla="*/ 389 h 476"/>
                <a:gd name="T70" fmla="*/ 1098 w 1713"/>
                <a:gd name="T71" fmla="*/ 418 h 476"/>
                <a:gd name="T72" fmla="*/ 1136 w 1713"/>
                <a:gd name="T73" fmla="*/ 418 h 476"/>
                <a:gd name="T74" fmla="*/ 1136 w 1713"/>
                <a:gd name="T75" fmla="*/ 447 h 476"/>
                <a:gd name="T76" fmla="*/ 1276 w 1713"/>
                <a:gd name="T77" fmla="*/ 447 h 476"/>
                <a:gd name="T78" fmla="*/ 1328 w 1713"/>
                <a:gd name="T79" fmla="*/ 447 h 476"/>
                <a:gd name="T80" fmla="*/ 1328 w 1713"/>
                <a:gd name="T81" fmla="*/ 476 h 476"/>
                <a:gd name="T82" fmla="*/ 1608 w 1713"/>
                <a:gd name="T83" fmla="*/ 476 h 476"/>
                <a:gd name="T84" fmla="*/ 1713 w 1713"/>
                <a:gd name="T85" fmla="*/ 476 h 4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</a:cxnLst>
              <a:rect l="0" t="0" r="r" b="b"/>
              <a:pathLst>
                <a:path w="1713" h="476">
                  <a:moveTo>
                    <a:pt x="0" y="0"/>
                  </a:moveTo>
                  <a:lnTo>
                    <a:pt x="0" y="0"/>
                  </a:lnTo>
                  <a:lnTo>
                    <a:pt x="0" y="24"/>
                  </a:lnTo>
                  <a:lnTo>
                    <a:pt x="130" y="24"/>
                  </a:lnTo>
                  <a:lnTo>
                    <a:pt x="130" y="48"/>
                  </a:lnTo>
                  <a:lnTo>
                    <a:pt x="150" y="48"/>
                  </a:lnTo>
                  <a:lnTo>
                    <a:pt x="188" y="48"/>
                  </a:lnTo>
                  <a:lnTo>
                    <a:pt x="188" y="72"/>
                  </a:lnTo>
                  <a:lnTo>
                    <a:pt x="304" y="72"/>
                  </a:lnTo>
                  <a:lnTo>
                    <a:pt x="304" y="96"/>
                  </a:lnTo>
                  <a:lnTo>
                    <a:pt x="308" y="120"/>
                  </a:lnTo>
                  <a:lnTo>
                    <a:pt x="434" y="120"/>
                  </a:lnTo>
                  <a:lnTo>
                    <a:pt x="434" y="149"/>
                  </a:lnTo>
                  <a:lnTo>
                    <a:pt x="458" y="149"/>
                  </a:lnTo>
                  <a:lnTo>
                    <a:pt x="563" y="149"/>
                  </a:lnTo>
                  <a:lnTo>
                    <a:pt x="563" y="173"/>
                  </a:lnTo>
                  <a:lnTo>
                    <a:pt x="583" y="173"/>
                  </a:lnTo>
                  <a:lnTo>
                    <a:pt x="592" y="173"/>
                  </a:lnTo>
                  <a:lnTo>
                    <a:pt x="592" y="202"/>
                  </a:lnTo>
                  <a:lnTo>
                    <a:pt x="592" y="226"/>
                  </a:lnTo>
                  <a:lnTo>
                    <a:pt x="660" y="226"/>
                  </a:lnTo>
                  <a:lnTo>
                    <a:pt x="660" y="255"/>
                  </a:lnTo>
                  <a:lnTo>
                    <a:pt x="910" y="255"/>
                  </a:lnTo>
                  <a:lnTo>
                    <a:pt x="919" y="255"/>
                  </a:lnTo>
                  <a:lnTo>
                    <a:pt x="919" y="279"/>
                  </a:lnTo>
                  <a:lnTo>
                    <a:pt x="934" y="279"/>
                  </a:lnTo>
                  <a:lnTo>
                    <a:pt x="934" y="308"/>
                  </a:lnTo>
                  <a:lnTo>
                    <a:pt x="1040" y="308"/>
                  </a:lnTo>
                  <a:lnTo>
                    <a:pt x="1049" y="308"/>
                  </a:lnTo>
                  <a:lnTo>
                    <a:pt x="1049" y="336"/>
                  </a:lnTo>
                  <a:lnTo>
                    <a:pt x="1073" y="336"/>
                  </a:lnTo>
                  <a:lnTo>
                    <a:pt x="1073" y="365"/>
                  </a:lnTo>
                  <a:lnTo>
                    <a:pt x="1083" y="365"/>
                  </a:lnTo>
                  <a:lnTo>
                    <a:pt x="1083" y="389"/>
                  </a:lnTo>
                  <a:lnTo>
                    <a:pt x="1098" y="389"/>
                  </a:lnTo>
                  <a:lnTo>
                    <a:pt x="1098" y="418"/>
                  </a:lnTo>
                  <a:lnTo>
                    <a:pt x="1136" y="418"/>
                  </a:lnTo>
                  <a:lnTo>
                    <a:pt x="1136" y="447"/>
                  </a:lnTo>
                  <a:lnTo>
                    <a:pt x="1276" y="447"/>
                  </a:lnTo>
                  <a:lnTo>
                    <a:pt x="1328" y="447"/>
                  </a:lnTo>
                  <a:lnTo>
                    <a:pt x="1328" y="476"/>
                  </a:lnTo>
                  <a:lnTo>
                    <a:pt x="1608" y="476"/>
                  </a:lnTo>
                  <a:lnTo>
                    <a:pt x="1713" y="476"/>
                  </a:lnTo>
                </a:path>
              </a:pathLst>
            </a:custGeom>
            <a:noFill/>
            <a:ln w="12700">
              <a:solidFill>
                <a:schemeClr val="tx1"/>
              </a:solidFill>
              <a:prstDash val="lgDashDot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Line 78">
              <a:extLst>
                <a:ext uri="{FF2B5EF4-FFF2-40B4-BE49-F238E27FC236}">
                  <a16:creationId xmlns:a16="http://schemas.microsoft.com/office/drawing/2014/main" id="{49BB0272-36D8-4B8F-B1FB-0276B44603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-2199" y="1266"/>
              <a:ext cx="0" cy="1155"/>
            </a:xfrm>
            <a:prstGeom prst="line">
              <a:avLst/>
            </a:prstGeom>
            <a:noFill/>
            <a:ln w="793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Line 79">
              <a:extLst>
                <a:ext uri="{FF2B5EF4-FFF2-40B4-BE49-F238E27FC236}">
                  <a16:creationId xmlns:a16="http://schemas.microsoft.com/office/drawing/2014/main" id="{DFD587BD-9346-4D29-9EAB-E34138CD71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-2199" y="2421"/>
              <a:ext cx="1713" cy="0"/>
            </a:xfrm>
            <a:prstGeom prst="line">
              <a:avLst/>
            </a:prstGeom>
            <a:noFill/>
            <a:ln w="7938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Line 80">
              <a:extLst>
                <a:ext uri="{FF2B5EF4-FFF2-40B4-BE49-F238E27FC236}">
                  <a16:creationId xmlns:a16="http://schemas.microsoft.com/office/drawing/2014/main" id="{23FBEE4F-4128-4D7F-896D-59C573F3C22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025" y="2421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Line 81">
              <a:extLst>
                <a:ext uri="{FF2B5EF4-FFF2-40B4-BE49-F238E27FC236}">
                  <a16:creationId xmlns:a16="http://schemas.microsoft.com/office/drawing/2014/main" id="{74CD75D2-4F29-4A8D-A09C-FE99F9F595B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684" y="2421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Line 82">
              <a:extLst>
                <a:ext uri="{FF2B5EF4-FFF2-40B4-BE49-F238E27FC236}">
                  <a16:creationId xmlns:a16="http://schemas.microsoft.com/office/drawing/2014/main" id="{56F53449-E2A0-48CC-B577-8234008FA32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342" y="2421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Line 83">
              <a:extLst>
                <a:ext uri="{FF2B5EF4-FFF2-40B4-BE49-F238E27FC236}">
                  <a16:creationId xmlns:a16="http://schemas.microsoft.com/office/drawing/2014/main" id="{F09F7357-12D8-4D13-A744-1828994803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000" y="2421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Line 84">
              <a:extLst>
                <a:ext uri="{FF2B5EF4-FFF2-40B4-BE49-F238E27FC236}">
                  <a16:creationId xmlns:a16="http://schemas.microsoft.com/office/drawing/2014/main" id="{87393A10-6B55-48C8-B0A0-900BB1169B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659" y="2421"/>
              <a:ext cx="0" cy="14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Line 85">
              <a:extLst>
                <a:ext uri="{FF2B5EF4-FFF2-40B4-BE49-F238E27FC236}">
                  <a16:creationId xmlns:a16="http://schemas.microsoft.com/office/drawing/2014/main" id="{B8344559-CE44-44E4-A8B3-A3A0DC2372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2199" y="2421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Line 86">
              <a:extLst>
                <a:ext uri="{FF2B5EF4-FFF2-40B4-BE49-F238E27FC236}">
                  <a16:creationId xmlns:a16="http://schemas.microsoft.com/office/drawing/2014/main" id="{0D3A0374-AC80-4206-B3A4-28CCF42FE21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857" y="2421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Line 87">
              <a:extLst>
                <a:ext uri="{FF2B5EF4-FFF2-40B4-BE49-F238E27FC236}">
                  <a16:creationId xmlns:a16="http://schemas.microsoft.com/office/drawing/2014/main" id="{1C414525-2F47-46D5-AD47-91D7A97DDA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515" y="2421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Line 88">
              <a:extLst>
                <a:ext uri="{FF2B5EF4-FFF2-40B4-BE49-F238E27FC236}">
                  <a16:creationId xmlns:a16="http://schemas.microsoft.com/office/drawing/2014/main" id="{0D09BFED-6C71-4B8C-8F8C-9A853ADCEFF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1169" y="2421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Line 89">
              <a:extLst>
                <a:ext uri="{FF2B5EF4-FFF2-40B4-BE49-F238E27FC236}">
                  <a16:creationId xmlns:a16="http://schemas.microsoft.com/office/drawing/2014/main" id="{ECFBA540-9191-492A-BC0C-D86CE93219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827" y="2421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Line 90">
              <a:extLst>
                <a:ext uri="{FF2B5EF4-FFF2-40B4-BE49-F238E27FC236}">
                  <a16:creationId xmlns:a16="http://schemas.microsoft.com/office/drawing/2014/main" id="{F273DDCB-0371-4FE5-A037-A5CBD35DB0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-486" y="2421"/>
              <a:ext cx="0" cy="29"/>
            </a:xfrm>
            <a:prstGeom prst="line">
              <a:avLst/>
            </a:prstGeom>
            <a:noFill/>
            <a:ln w="7938">
              <a:solidFill>
                <a:srgbClr val="A5A5A5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91">
              <a:extLst>
                <a:ext uri="{FF2B5EF4-FFF2-40B4-BE49-F238E27FC236}">
                  <a16:creationId xmlns:a16="http://schemas.microsoft.com/office/drawing/2014/main" id="{80B45834-418C-4F87-9FEA-9A961BBA87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218" y="2454"/>
              <a:ext cx="54" cy="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0</a:t>
              </a:r>
              <a:endParaRPr kumimoji="0" lang="ja-JP" altLang="ja-JP" sz="1200" b="0" i="0" u="none" strike="noStrike" cap="none" normalizeH="0" baseline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4" name="Rectangle 92">
              <a:extLst>
                <a:ext uri="{FF2B5EF4-FFF2-40B4-BE49-F238E27FC236}">
                  <a16:creationId xmlns:a16="http://schemas.microsoft.com/office/drawing/2014/main" id="{76320B0A-792F-4440-B7D9-F906FAE707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910" y="2454"/>
              <a:ext cx="8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12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5" name="Rectangle 93">
              <a:extLst>
                <a:ext uri="{FF2B5EF4-FFF2-40B4-BE49-F238E27FC236}">
                  <a16:creationId xmlns:a16="http://schemas.microsoft.com/office/drawing/2014/main" id="{57850506-96D9-4758-B838-6C72D9EDEB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568" y="2454"/>
              <a:ext cx="8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24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6" name="Rectangle 94">
              <a:extLst>
                <a:ext uri="{FF2B5EF4-FFF2-40B4-BE49-F238E27FC236}">
                  <a16:creationId xmlns:a16="http://schemas.microsoft.com/office/drawing/2014/main" id="{4D3FD612-EF87-45BF-A37E-4106009E47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1236" y="2454"/>
              <a:ext cx="8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36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7" name="Rectangle 95">
              <a:extLst>
                <a:ext uri="{FF2B5EF4-FFF2-40B4-BE49-F238E27FC236}">
                  <a16:creationId xmlns:a16="http://schemas.microsoft.com/office/drawing/2014/main" id="{336FFF6F-0707-49E3-9ECD-FDA2690A2D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895" y="2454"/>
              <a:ext cx="8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48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98" name="Rectangle 96">
              <a:extLst>
                <a:ext uri="{FF2B5EF4-FFF2-40B4-BE49-F238E27FC236}">
                  <a16:creationId xmlns:a16="http://schemas.microsoft.com/office/drawing/2014/main" id="{6E530C46-FB2D-4F62-BDF0-C858831F12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577" y="2454"/>
              <a:ext cx="83" cy="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hangingPunct="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effectLst/>
                  <a:ea typeface="メイリオ" panose="020B0604030504040204" pitchFamily="50" charset="-128"/>
                  <a:cs typeface="Arial" panose="020B0604020202020204" pitchFamily="34" charset="0"/>
                </a:rPr>
                <a:t>60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BB5E7530-ADB7-4B09-A9BE-C70AE56D2D1C}"/>
              </a:ext>
            </a:extLst>
          </p:cNvPr>
          <p:cNvSpPr/>
          <p:nvPr/>
        </p:nvSpPr>
        <p:spPr>
          <a:xfrm>
            <a:off x="5411041" y="3511568"/>
            <a:ext cx="8483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0002</a:t>
            </a:r>
            <a:endParaRPr lang="ja-JP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Rectangle 95">
            <a:extLst>
              <a:ext uri="{FF2B5EF4-FFF2-40B4-BE49-F238E27FC236}">
                <a16:creationId xmlns:a16="http://schemas.microsoft.com/office/drawing/2014/main" id="{9FA5B357-D2D3-4015-8A56-F47BEB7AA3D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331674" y="1578833"/>
            <a:ext cx="1263166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900" dirty="0">
                <a:cs typeface="Arial" panose="020B0604020202020204" pitchFamily="34" charset="0"/>
              </a:rPr>
              <a:t>PT Normal complication-</a:t>
            </a:r>
            <a:endParaRPr kumimoji="1" lang="ja-JP" altLang="ja-JP" sz="9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05" name="Rectangle 95">
            <a:extLst>
              <a:ext uri="{FF2B5EF4-FFF2-40B4-BE49-F238E27FC236}">
                <a16:creationId xmlns:a16="http://schemas.microsoft.com/office/drawing/2014/main" id="{C06A41A6-1C00-4959-9381-61018D7360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001660" y="1731233"/>
            <a:ext cx="1128514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900" dirty="0">
                <a:cs typeface="Arial" panose="020B0604020202020204" pitchFamily="34" charset="0"/>
              </a:rPr>
              <a:t>PT High complication-</a:t>
            </a:r>
            <a:endParaRPr kumimoji="1" lang="ja-JP" altLang="ja-JP" sz="9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06" name="Rectangle 95">
            <a:extLst>
              <a:ext uri="{FF2B5EF4-FFF2-40B4-BE49-F238E27FC236}">
                <a16:creationId xmlns:a16="http://schemas.microsoft.com/office/drawing/2014/main" id="{22C5DD61-84F6-4025-9539-54AE486A9C2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94967" y="2581360"/>
            <a:ext cx="1157368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900" dirty="0">
                <a:cs typeface="Arial" panose="020B0604020202020204" pitchFamily="34" charset="0"/>
              </a:rPr>
              <a:t>PT High complication+</a:t>
            </a:r>
            <a:endParaRPr kumimoji="1" lang="ja-JP" altLang="ja-JP" sz="9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sp>
        <p:nvSpPr>
          <p:cNvPr id="107" name="Rectangle 95">
            <a:extLst>
              <a:ext uri="{FF2B5EF4-FFF2-40B4-BE49-F238E27FC236}">
                <a16:creationId xmlns:a16="http://schemas.microsoft.com/office/drawing/2014/main" id="{1CAFC9AB-2436-47EA-BAE3-5D3F073591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53085" y="1921014"/>
            <a:ext cx="129202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 kumimoji="1">
                <a:solidFill>
                  <a:schemeClr val="tx1"/>
                </a:solidFill>
                <a:latin typeface="Arial" pitchFamily="34" charset="0"/>
                <a:ea typeface="ＭＳ Ｐゴシック" pitchFamily="50" charset="-128"/>
                <a:cs typeface="ＭＳ Ｐゴシック" pitchFamily="50" charset="-128"/>
              </a:defRPr>
            </a:lvl9pPr>
          </a:lstStyle>
          <a:p>
            <a:pPr lvl="0"/>
            <a:r>
              <a:rPr lang="en-US" altLang="ja-JP" sz="900" dirty="0">
                <a:cs typeface="Arial" panose="020B0604020202020204" pitchFamily="34" charset="0"/>
              </a:rPr>
              <a:t>PT Normal complication+</a:t>
            </a:r>
            <a:endParaRPr kumimoji="1" lang="ja-JP" altLang="ja-JP" sz="900" b="0" i="0" u="none" strike="noStrike" cap="none" normalizeH="0" baseline="0" dirty="0">
              <a:ln>
                <a:noFill/>
              </a:ln>
              <a:effectLst/>
              <a:cs typeface="Arial" panose="020B0604020202020204" pitchFamily="34" charset="0"/>
            </a:endParaRPr>
          </a:p>
        </p:txBody>
      </p:sp>
      <p:grpSp>
        <p:nvGrpSpPr>
          <p:cNvPr id="108" name="グループ化 107">
            <a:extLst>
              <a:ext uri="{FF2B5EF4-FFF2-40B4-BE49-F238E27FC236}">
                <a16:creationId xmlns:a16="http://schemas.microsoft.com/office/drawing/2014/main" id="{89EF6222-5743-4787-827E-FA0B0ECA30C5}"/>
              </a:ext>
            </a:extLst>
          </p:cNvPr>
          <p:cNvGrpSpPr/>
          <p:nvPr/>
        </p:nvGrpSpPr>
        <p:grpSpPr>
          <a:xfrm>
            <a:off x="-99223" y="4230297"/>
            <a:ext cx="4778172" cy="1106910"/>
            <a:chOff x="375776" y="2866680"/>
            <a:chExt cx="4778172" cy="1106910"/>
          </a:xfrm>
        </p:grpSpPr>
        <p:grpSp>
          <p:nvGrpSpPr>
            <p:cNvPr id="109" name="グループ化 108">
              <a:extLst>
                <a:ext uri="{FF2B5EF4-FFF2-40B4-BE49-F238E27FC236}">
                  <a16:creationId xmlns:a16="http://schemas.microsoft.com/office/drawing/2014/main" id="{3320B114-C6BF-4635-977A-752E6941544A}"/>
                </a:ext>
              </a:extLst>
            </p:cNvPr>
            <p:cNvGrpSpPr/>
            <p:nvPr/>
          </p:nvGrpSpPr>
          <p:grpSpPr>
            <a:xfrm>
              <a:off x="375776" y="2866680"/>
              <a:ext cx="3253365" cy="1106910"/>
              <a:chOff x="-278416" y="4549408"/>
              <a:chExt cx="3253365" cy="1106910"/>
            </a:xfrm>
          </p:grpSpPr>
          <p:sp>
            <p:nvSpPr>
              <p:cNvPr id="112" name="Rectangle 95">
                <a:extLst>
                  <a:ext uri="{FF2B5EF4-FFF2-40B4-BE49-F238E27FC236}">
                    <a16:creationId xmlns:a16="http://schemas.microsoft.com/office/drawing/2014/main" id="{7431D400-4C32-45D1-BF29-6550EEF788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999" y="4549408"/>
                <a:ext cx="63318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lvl="0"/>
                <a:r>
                  <a:rPr lang="en-US" altLang="ja-JP" sz="1100" dirty="0">
                    <a:cs typeface="Arial" panose="020B0604020202020204" pitchFamily="34" charset="0"/>
                  </a:rPr>
                  <a:t>No. at risk</a:t>
                </a:r>
                <a:endParaRPr kumimoji="1" lang="ja-JP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13" name="正方形/長方形 112">
                <a:extLst>
                  <a:ext uri="{FF2B5EF4-FFF2-40B4-BE49-F238E27FC236}">
                    <a16:creationId xmlns:a16="http://schemas.microsoft.com/office/drawing/2014/main" id="{D533BFF0-B05F-4485-AC33-735F4EB58FC3}"/>
                  </a:ext>
                </a:extLst>
              </p:cNvPr>
              <p:cNvSpPr/>
              <p:nvPr/>
            </p:nvSpPr>
            <p:spPr>
              <a:xfrm>
                <a:off x="-278416" y="4682012"/>
                <a:ext cx="901479" cy="97430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>
                  <a:lnSpc>
                    <a:spcPts val="1400"/>
                  </a:lnSpc>
                </a:pP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 comp-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w</a:t>
                </a:r>
                <a:r>
                  <a:rPr lang="ja-JP" alt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omp-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igh comp+</a:t>
                </a:r>
              </a:p>
              <a:p>
                <a:pPr>
                  <a:lnSpc>
                    <a:spcPts val="1400"/>
                  </a:lnSpc>
                </a:pP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Low comp+</a:t>
                </a:r>
              </a:p>
              <a:p>
                <a:pPr>
                  <a:lnSpc>
                    <a:spcPts val="1400"/>
                  </a:lnSpc>
                </a:pPr>
                <a:endPara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正方形/長方形 113">
                <a:extLst>
                  <a:ext uri="{FF2B5EF4-FFF2-40B4-BE49-F238E27FC236}">
                    <a16:creationId xmlns:a16="http://schemas.microsoft.com/office/drawing/2014/main" id="{A35A5F35-BF5E-4A4C-979F-427E78AF4F3C}"/>
                  </a:ext>
                </a:extLst>
              </p:cNvPr>
              <p:cNvSpPr/>
              <p:nvPr/>
            </p:nvSpPr>
            <p:spPr>
              <a:xfrm>
                <a:off x="411926" y="4723756"/>
                <a:ext cx="573866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90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7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1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正方形/長方形 114">
                <a:extLst>
                  <a:ext uri="{FF2B5EF4-FFF2-40B4-BE49-F238E27FC236}">
                    <a16:creationId xmlns:a16="http://schemas.microsoft.com/office/drawing/2014/main" id="{E649B02C-92F9-4497-995F-857654EE13F4}"/>
                  </a:ext>
                </a:extLst>
              </p:cNvPr>
              <p:cNvSpPr/>
              <p:nvPr/>
            </p:nvSpPr>
            <p:spPr>
              <a:xfrm>
                <a:off x="1030823" y="4718685"/>
                <a:ext cx="573866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4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83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1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6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正方形/長方形 115">
                <a:extLst>
                  <a:ext uri="{FF2B5EF4-FFF2-40B4-BE49-F238E27FC236}">
                    <a16:creationId xmlns:a16="http://schemas.microsoft.com/office/drawing/2014/main" id="{EED35364-B104-4084-B636-0EBB8774C7D1}"/>
                  </a:ext>
                </a:extLst>
              </p:cNvPr>
              <p:cNvSpPr/>
              <p:nvPr/>
            </p:nvSpPr>
            <p:spPr>
              <a:xfrm>
                <a:off x="1687449" y="4718684"/>
                <a:ext cx="573866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7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4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正方形/長方形 116">
                <a:extLst>
                  <a:ext uri="{FF2B5EF4-FFF2-40B4-BE49-F238E27FC236}">
                    <a16:creationId xmlns:a16="http://schemas.microsoft.com/office/drawing/2014/main" id="{ED597CE7-FF1D-4A25-94AD-881446A05D36}"/>
                  </a:ext>
                </a:extLst>
              </p:cNvPr>
              <p:cNvSpPr/>
              <p:nvPr/>
            </p:nvSpPr>
            <p:spPr>
              <a:xfrm>
                <a:off x="2401083" y="4728617"/>
                <a:ext cx="573866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2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1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1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0" name="正方形/長方形 109">
              <a:extLst>
                <a:ext uri="{FF2B5EF4-FFF2-40B4-BE49-F238E27FC236}">
                  <a16:creationId xmlns:a16="http://schemas.microsoft.com/office/drawing/2014/main" id="{C286129E-5F8E-4EC5-9210-2FFFDF6689F8}"/>
                </a:ext>
              </a:extLst>
            </p:cNvPr>
            <p:cNvSpPr/>
            <p:nvPr/>
          </p:nvSpPr>
          <p:spPr>
            <a:xfrm>
              <a:off x="3866925" y="3033236"/>
              <a:ext cx="573866" cy="76944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59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正方形/長方形 110">
              <a:extLst>
                <a:ext uri="{FF2B5EF4-FFF2-40B4-BE49-F238E27FC236}">
                  <a16:creationId xmlns:a16="http://schemas.microsoft.com/office/drawing/2014/main" id="{2297EC18-0898-4124-9B6A-2134E638AE88}"/>
                </a:ext>
              </a:extLst>
            </p:cNvPr>
            <p:cNvSpPr/>
            <p:nvPr/>
          </p:nvSpPr>
          <p:spPr>
            <a:xfrm>
              <a:off x="4580082" y="3033235"/>
              <a:ext cx="573866" cy="76944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8" name="グループ化 117">
            <a:extLst>
              <a:ext uri="{FF2B5EF4-FFF2-40B4-BE49-F238E27FC236}">
                <a16:creationId xmlns:a16="http://schemas.microsoft.com/office/drawing/2014/main" id="{80652289-E294-4CC2-A7FF-3BBF6F16E584}"/>
              </a:ext>
            </a:extLst>
          </p:cNvPr>
          <p:cNvGrpSpPr/>
          <p:nvPr/>
        </p:nvGrpSpPr>
        <p:grpSpPr>
          <a:xfrm>
            <a:off x="5010015" y="4184696"/>
            <a:ext cx="4133985" cy="948650"/>
            <a:chOff x="830191" y="2866680"/>
            <a:chExt cx="4133985" cy="948650"/>
          </a:xfrm>
        </p:grpSpPr>
        <p:grpSp>
          <p:nvGrpSpPr>
            <p:cNvPr id="119" name="グループ化 118">
              <a:extLst>
                <a:ext uri="{FF2B5EF4-FFF2-40B4-BE49-F238E27FC236}">
                  <a16:creationId xmlns:a16="http://schemas.microsoft.com/office/drawing/2014/main" id="{0FA64AE0-B73B-470A-A996-63AE8C2693E7}"/>
                </a:ext>
              </a:extLst>
            </p:cNvPr>
            <p:cNvGrpSpPr/>
            <p:nvPr/>
          </p:nvGrpSpPr>
          <p:grpSpPr>
            <a:xfrm>
              <a:off x="830191" y="2866680"/>
              <a:ext cx="2755820" cy="948650"/>
              <a:chOff x="175999" y="4549408"/>
              <a:chExt cx="2755820" cy="948650"/>
            </a:xfrm>
          </p:grpSpPr>
          <p:sp>
            <p:nvSpPr>
              <p:cNvPr id="122" name="Rectangle 95">
                <a:extLst>
                  <a:ext uri="{FF2B5EF4-FFF2-40B4-BE49-F238E27FC236}">
                    <a16:creationId xmlns:a16="http://schemas.microsoft.com/office/drawing/2014/main" id="{3A87899B-2899-4D46-8BF3-0E1B2509A0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999" y="4549408"/>
                <a:ext cx="633187" cy="16927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ＭＳ Ｐゴシック" pitchFamily="50" charset="-128"/>
                  </a:defRPr>
                </a:lvl9pPr>
              </a:lstStyle>
              <a:p>
                <a:pPr lvl="0"/>
                <a:r>
                  <a:rPr lang="en-US" altLang="ja-JP" sz="1100" dirty="0">
                    <a:cs typeface="Arial" panose="020B0604020202020204" pitchFamily="34" charset="0"/>
                  </a:rPr>
                  <a:t>No. at risk</a:t>
                </a:r>
                <a:endParaRPr kumimoji="1" lang="ja-JP" altLang="ja-JP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24" name="正方形/長方形 123">
                <a:extLst>
                  <a:ext uri="{FF2B5EF4-FFF2-40B4-BE49-F238E27FC236}">
                    <a16:creationId xmlns:a16="http://schemas.microsoft.com/office/drawing/2014/main" id="{D332BC11-4D63-4362-9743-A9B09CF96072}"/>
                  </a:ext>
                </a:extLst>
              </p:cNvPr>
              <p:cNvSpPr/>
              <p:nvPr/>
            </p:nvSpPr>
            <p:spPr>
              <a:xfrm>
                <a:off x="401070" y="4723756"/>
                <a:ext cx="573866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94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7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正方形/長方形 124">
                <a:extLst>
                  <a:ext uri="{FF2B5EF4-FFF2-40B4-BE49-F238E27FC236}">
                    <a16:creationId xmlns:a16="http://schemas.microsoft.com/office/drawing/2014/main" id="{53163701-9144-4E28-AFB6-F8613ACC6E68}"/>
                  </a:ext>
                </a:extLst>
              </p:cNvPr>
              <p:cNvSpPr/>
              <p:nvPr/>
            </p:nvSpPr>
            <p:spPr>
              <a:xfrm>
                <a:off x="987693" y="4718685"/>
                <a:ext cx="573866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93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4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7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41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正方形/長方形 125">
                <a:extLst>
                  <a:ext uri="{FF2B5EF4-FFF2-40B4-BE49-F238E27FC236}">
                    <a16:creationId xmlns:a16="http://schemas.microsoft.com/office/drawing/2014/main" id="{58D9E21C-57F0-481B-8965-E128DE1ADEE6}"/>
                  </a:ext>
                </a:extLst>
              </p:cNvPr>
              <p:cNvSpPr/>
              <p:nvPr/>
            </p:nvSpPr>
            <p:spPr>
              <a:xfrm>
                <a:off x="1644319" y="4718684"/>
                <a:ext cx="573866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86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70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2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4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正方形/長方形 126">
                <a:extLst>
                  <a:ext uri="{FF2B5EF4-FFF2-40B4-BE49-F238E27FC236}">
                    <a16:creationId xmlns:a16="http://schemas.microsoft.com/office/drawing/2014/main" id="{CFF1C4D3-0DB4-463E-A8A6-330760899C0D}"/>
                  </a:ext>
                </a:extLst>
              </p:cNvPr>
              <p:cNvSpPr/>
              <p:nvPr/>
            </p:nvSpPr>
            <p:spPr>
              <a:xfrm>
                <a:off x="2357953" y="4728617"/>
                <a:ext cx="573866" cy="76944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83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62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</a:p>
              <a:p>
                <a:r>
                  <a:rPr lang="en-US" altLang="ja-JP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31</a:t>
                </a:r>
                <a:endParaRPr lang="ja-JP" alt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20" name="正方形/長方形 119">
              <a:extLst>
                <a:ext uri="{FF2B5EF4-FFF2-40B4-BE49-F238E27FC236}">
                  <a16:creationId xmlns:a16="http://schemas.microsoft.com/office/drawing/2014/main" id="{B6D21389-2684-48A1-845B-E80E23ECAF76}"/>
                </a:ext>
              </a:extLst>
            </p:cNvPr>
            <p:cNvSpPr/>
            <p:nvPr/>
          </p:nvSpPr>
          <p:spPr>
            <a:xfrm>
              <a:off x="3677153" y="3033236"/>
              <a:ext cx="573866" cy="76944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79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61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1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3</a:t>
              </a:r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正方形/長方形 120">
              <a:extLst>
                <a:ext uri="{FF2B5EF4-FFF2-40B4-BE49-F238E27FC236}">
                  <a16:creationId xmlns:a16="http://schemas.microsoft.com/office/drawing/2014/main" id="{70E2472B-0745-4903-8F6A-B76910B89E9A}"/>
                </a:ext>
              </a:extLst>
            </p:cNvPr>
            <p:cNvSpPr/>
            <p:nvPr/>
          </p:nvSpPr>
          <p:spPr>
            <a:xfrm>
              <a:off x="4390310" y="3033235"/>
              <a:ext cx="573866" cy="76944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77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54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  <a:p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22</a:t>
              </a:r>
              <a:endParaRPr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8" name="正方形/長方形 127">
            <a:extLst>
              <a:ext uri="{FF2B5EF4-FFF2-40B4-BE49-F238E27FC236}">
                <a16:creationId xmlns:a16="http://schemas.microsoft.com/office/drawing/2014/main" id="{01C39742-FF87-4A0B-9796-419F5FB53972}"/>
              </a:ext>
            </a:extLst>
          </p:cNvPr>
          <p:cNvSpPr/>
          <p:nvPr/>
        </p:nvSpPr>
        <p:spPr>
          <a:xfrm>
            <a:off x="4409516" y="4334146"/>
            <a:ext cx="1016499" cy="9743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ts val="14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rmal comp-</a:t>
            </a:r>
          </a:p>
          <a:p>
            <a:pPr>
              <a:lnSpc>
                <a:spcPts val="14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igh</a:t>
            </a:r>
            <a:r>
              <a:rPr lang="ja-JP" alt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omp-</a:t>
            </a:r>
          </a:p>
          <a:p>
            <a:pPr>
              <a:lnSpc>
                <a:spcPts val="14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Normal comp+</a:t>
            </a:r>
          </a:p>
          <a:p>
            <a:pPr>
              <a:lnSpc>
                <a:spcPts val="1400"/>
              </a:lnSpc>
            </a:pP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igh comp+</a:t>
            </a:r>
          </a:p>
          <a:p>
            <a:pPr>
              <a:lnSpc>
                <a:spcPts val="1400"/>
              </a:lnSpc>
            </a:pPr>
            <a:endParaRPr lang="en-US" altLang="ja-JP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正方形/長方形 128">
            <a:extLst>
              <a:ext uri="{FF2B5EF4-FFF2-40B4-BE49-F238E27FC236}">
                <a16:creationId xmlns:a16="http://schemas.microsoft.com/office/drawing/2014/main" id="{2FB66517-03D8-4DDA-9E73-C876C333A82D}"/>
              </a:ext>
            </a:extLst>
          </p:cNvPr>
          <p:cNvSpPr/>
          <p:nvPr/>
        </p:nvSpPr>
        <p:spPr>
          <a:xfrm>
            <a:off x="0" y="-3322"/>
            <a:ext cx="184698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. 1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正方形/長方形 129">
            <a:extLst>
              <a:ext uri="{FF2B5EF4-FFF2-40B4-BE49-F238E27FC236}">
                <a16:creationId xmlns:a16="http://schemas.microsoft.com/office/drawing/2014/main" id="{E6F4C9F2-FD65-4668-8803-4CC8E88D277B}"/>
              </a:ext>
            </a:extLst>
          </p:cNvPr>
          <p:cNvSpPr/>
          <p:nvPr/>
        </p:nvSpPr>
        <p:spPr>
          <a:xfrm>
            <a:off x="68337" y="274094"/>
            <a:ext cx="33214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正方形/長方形 130">
            <a:extLst>
              <a:ext uri="{FF2B5EF4-FFF2-40B4-BE49-F238E27FC236}">
                <a16:creationId xmlns:a16="http://schemas.microsoft.com/office/drawing/2014/main" id="{4B71C09A-29DF-475A-99B5-9FF43F170C20}"/>
              </a:ext>
            </a:extLst>
          </p:cNvPr>
          <p:cNvSpPr/>
          <p:nvPr/>
        </p:nvSpPr>
        <p:spPr>
          <a:xfrm>
            <a:off x="4681355" y="335232"/>
            <a:ext cx="320922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34927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3</TotalTime>
  <Words>150</Words>
  <Application>Microsoft Office PowerPoint</Application>
  <PresentationFormat>画面に合わせる (4:3)</PresentationFormat>
  <Paragraphs>9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弘二郎 江藤</dc:creator>
  <cp:lastModifiedBy>江藤 弘二郎</cp:lastModifiedBy>
  <cp:revision>23</cp:revision>
  <dcterms:created xsi:type="dcterms:W3CDTF">2019-01-27T01:47:13Z</dcterms:created>
  <dcterms:modified xsi:type="dcterms:W3CDTF">2021-12-17T23:32:29Z</dcterms:modified>
</cp:coreProperties>
</file>